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6" r:id="rId4"/>
  </p:sldMasterIdLst>
  <p:sldIdLst>
    <p:sldId id="256" r:id="rId5"/>
  </p:sldIdLst>
  <p:sldSz cx="21674138" cy="28898850"/>
  <p:notesSz cx="6794500" cy="9906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0D8F673-FB0B-4B6C-B731-75A26EEC2BB5}" v="55" dt="2022-12-21T16:10:17.41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6672" autoAdjust="0"/>
    <p:restoredTop sz="94660"/>
  </p:normalViewPr>
  <p:slideViewPr>
    <p:cSldViewPr snapToGrid="0">
      <p:cViewPr>
        <p:scale>
          <a:sx n="39" d="100"/>
          <a:sy n="39" d="100"/>
        </p:scale>
        <p:origin x="1026" y="-25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laire Beraud" userId="S::claire.beraud@urosphere.com::88d8f020-165f-4369-a606-bc2a6e18c31d" providerId="AD" clId="Web-{CF68DAE0-3561-48FE-9374-11B1AA1023B0}"/>
    <pc:docChg chg="modSld">
      <pc:chgData name="Claire Beraud" userId="S::claire.beraud@urosphere.com::88d8f020-165f-4369-a606-bc2a6e18c31d" providerId="AD" clId="Web-{CF68DAE0-3561-48FE-9374-11B1AA1023B0}" dt="2022-12-12T14:42:19.250" v="22" actId="20577"/>
      <pc:docMkLst>
        <pc:docMk/>
      </pc:docMkLst>
      <pc:sldChg chg="addSp delSp modSp">
        <pc:chgData name="Claire Beraud" userId="S::claire.beraud@urosphere.com::88d8f020-165f-4369-a606-bc2a6e18c31d" providerId="AD" clId="Web-{CF68DAE0-3561-48FE-9374-11B1AA1023B0}" dt="2022-12-12T14:42:19.250" v="22" actId="20577"/>
        <pc:sldMkLst>
          <pc:docMk/>
          <pc:sldMk cId="677841024" sldId="256"/>
        </pc:sldMkLst>
        <pc:spChg chg="add del mod">
          <ac:chgData name="Claire Beraud" userId="S::claire.beraud@urosphere.com::88d8f020-165f-4369-a606-bc2a6e18c31d" providerId="AD" clId="Web-{CF68DAE0-3561-48FE-9374-11B1AA1023B0}" dt="2022-12-12T14:42:19.250" v="22" actId="20577"/>
          <ac:spMkLst>
            <pc:docMk/>
            <pc:sldMk cId="677841024" sldId="256"/>
            <ac:spMk id="2" creationId="{8FBD1D0F-68C2-AC70-EF99-EF56D33A2BC3}"/>
          </ac:spMkLst>
        </pc:spChg>
        <pc:spChg chg="add del mod">
          <ac:chgData name="Claire Beraud" userId="S::claire.beraud@urosphere.com::88d8f020-165f-4369-a606-bc2a6e18c31d" providerId="AD" clId="Web-{CF68DAE0-3561-48FE-9374-11B1AA1023B0}" dt="2022-12-12T14:41:35.858" v="6"/>
          <ac:spMkLst>
            <pc:docMk/>
            <pc:sldMk cId="677841024" sldId="256"/>
            <ac:spMk id="4" creationId="{39AFDF53-7DCA-0AD8-1237-56CDE3C88077}"/>
          </ac:spMkLst>
        </pc:spChg>
      </pc:sldChg>
    </pc:docChg>
  </pc:docChgLst>
  <pc:docChgLst>
    <pc:chgData name="Nadege Bidan" userId="101290c6-d7fd-4e4f-abb4-82cb3a45689d" providerId="ADAL" clId="{70D8F673-FB0B-4B6C-B731-75A26EEC2BB5}"/>
    <pc:docChg chg="undo custSel delSld modSld">
      <pc:chgData name="Nadege Bidan" userId="101290c6-d7fd-4e4f-abb4-82cb3a45689d" providerId="ADAL" clId="{70D8F673-FB0B-4B6C-B731-75A26EEC2BB5}" dt="2022-12-21T16:10:45.382" v="1265" actId="1036"/>
      <pc:docMkLst>
        <pc:docMk/>
      </pc:docMkLst>
      <pc:sldChg chg="addSp delSp modSp mod">
        <pc:chgData name="Nadege Bidan" userId="101290c6-d7fd-4e4f-abb4-82cb3a45689d" providerId="ADAL" clId="{70D8F673-FB0B-4B6C-B731-75A26EEC2BB5}" dt="2022-12-21T16:10:45.382" v="1265" actId="1036"/>
        <pc:sldMkLst>
          <pc:docMk/>
          <pc:sldMk cId="677841024" sldId="256"/>
        </pc:sldMkLst>
        <pc:spChg chg="add del mod">
          <ac:chgData name="Nadege Bidan" userId="101290c6-d7fd-4e4f-abb4-82cb3a45689d" providerId="ADAL" clId="{70D8F673-FB0B-4B6C-B731-75A26EEC2BB5}" dt="2022-12-21T16:07:32.280" v="1146" actId="478"/>
          <ac:spMkLst>
            <pc:docMk/>
            <pc:sldMk cId="677841024" sldId="256"/>
            <ac:spMk id="2" creationId="{7BD0930D-A23E-0D5C-5496-9AADBAEB6EDB}"/>
          </ac:spMkLst>
        </pc:spChg>
        <pc:spChg chg="mod">
          <ac:chgData name="Nadege Bidan" userId="101290c6-d7fd-4e4f-abb4-82cb3a45689d" providerId="ADAL" clId="{70D8F673-FB0B-4B6C-B731-75A26EEC2BB5}" dt="2022-12-15T10:14:38.302" v="813" actId="1035"/>
          <ac:spMkLst>
            <pc:docMk/>
            <pc:sldMk cId="677841024" sldId="256"/>
            <ac:spMk id="2" creationId="{8FBD1D0F-68C2-AC70-EF99-EF56D33A2BC3}"/>
          </ac:spMkLst>
        </pc:spChg>
        <pc:spChg chg="mod">
          <ac:chgData name="Nadege Bidan" userId="101290c6-d7fd-4e4f-abb4-82cb3a45689d" providerId="ADAL" clId="{70D8F673-FB0B-4B6C-B731-75A26EEC2BB5}" dt="2022-12-15T09:24:27.904" v="458" actId="1036"/>
          <ac:spMkLst>
            <pc:docMk/>
            <pc:sldMk cId="677841024" sldId="256"/>
            <ac:spMk id="3" creationId="{EF4B28D3-F739-DA0F-7ACB-AD6552D31A3F}"/>
          </ac:spMkLst>
        </pc:spChg>
        <pc:spChg chg="add mod">
          <ac:chgData name="Nadege Bidan" userId="101290c6-d7fd-4e4f-abb4-82cb3a45689d" providerId="ADAL" clId="{70D8F673-FB0B-4B6C-B731-75A26EEC2BB5}" dt="2022-12-15T10:14:22.466" v="808" actId="1036"/>
          <ac:spMkLst>
            <pc:docMk/>
            <pc:sldMk cId="677841024" sldId="256"/>
            <ac:spMk id="4" creationId="{BD287D1A-BD23-A006-AD0D-15F1A69ABE87}"/>
          </ac:spMkLst>
        </pc:spChg>
        <pc:spChg chg="add del mod">
          <ac:chgData name="Nadege Bidan" userId="101290c6-d7fd-4e4f-abb4-82cb3a45689d" providerId="ADAL" clId="{70D8F673-FB0B-4B6C-B731-75A26EEC2BB5}" dt="2022-12-21T16:07:40.009" v="1148" actId="478"/>
          <ac:spMkLst>
            <pc:docMk/>
            <pc:sldMk cId="677841024" sldId="256"/>
            <ac:spMk id="5" creationId="{A2D3BCFC-D342-2A76-3F5F-1271D21A99F6}"/>
          </ac:spMkLst>
        </pc:spChg>
        <pc:spChg chg="del mod topLvl">
          <ac:chgData name="Nadege Bidan" userId="101290c6-d7fd-4e4f-abb4-82cb3a45689d" providerId="ADAL" clId="{70D8F673-FB0B-4B6C-B731-75A26EEC2BB5}" dt="2022-12-15T09:23:37.251" v="429" actId="478"/>
          <ac:spMkLst>
            <pc:docMk/>
            <pc:sldMk cId="677841024" sldId="256"/>
            <ac:spMk id="12" creationId="{C41010EE-002E-E152-6203-C0F3E25631AB}"/>
          </ac:spMkLst>
        </pc:spChg>
        <pc:spChg chg="del mod topLvl">
          <ac:chgData name="Nadege Bidan" userId="101290c6-d7fd-4e4f-abb4-82cb3a45689d" providerId="ADAL" clId="{70D8F673-FB0B-4B6C-B731-75A26EEC2BB5}" dt="2022-12-15T09:23:42.770" v="430" actId="478"/>
          <ac:spMkLst>
            <pc:docMk/>
            <pc:sldMk cId="677841024" sldId="256"/>
            <ac:spMk id="13" creationId="{9B4E2D40-271D-78AA-BA16-6A50A742BE3C}"/>
          </ac:spMkLst>
        </pc:spChg>
        <pc:spChg chg="del mod topLvl">
          <ac:chgData name="Nadege Bidan" userId="101290c6-d7fd-4e4f-abb4-82cb3a45689d" providerId="ADAL" clId="{70D8F673-FB0B-4B6C-B731-75A26EEC2BB5}" dt="2022-12-15T09:23:42.770" v="430" actId="478"/>
          <ac:spMkLst>
            <pc:docMk/>
            <pc:sldMk cId="677841024" sldId="256"/>
            <ac:spMk id="14" creationId="{7C16A021-A53C-EE77-F703-40190984EB9D}"/>
          </ac:spMkLst>
        </pc:spChg>
        <pc:spChg chg="add del mod">
          <ac:chgData name="Nadege Bidan" userId="101290c6-d7fd-4e4f-abb4-82cb3a45689d" providerId="ADAL" clId="{70D8F673-FB0B-4B6C-B731-75A26EEC2BB5}" dt="2022-12-21T16:09:10.898" v="1186" actId="478"/>
          <ac:spMkLst>
            <pc:docMk/>
            <pc:sldMk cId="677841024" sldId="256"/>
            <ac:spMk id="14" creationId="{D7FF82EA-0030-63B8-AB95-EA782D7D8852}"/>
          </ac:spMkLst>
        </pc:spChg>
        <pc:spChg chg="add mod">
          <ac:chgData name="Nadege Bidan" userId="101290c6-d7fd-4e4f-abb4-82cb3a45689d" providerId="ADAL" clId="{70D8F673-FB0B-4B6C-B731-75A26EEC2BB5}" dt="2022-12-21T16:10:38.017" v="1249" actId="1035"/>
          <ac:spMkLst>
            <pc:docMk/>
            <pc:sldMk cId="677841024" sldId="256"/>
            <ac:spMk id="15" creationId="{25641737-FA59-3470-62DA-8E36DA9DAECF}"/>
          </ac:spMkLst>
        </pc:spChg>
        <pc:spChg chg="del mod topLvl">
          <ac:chgData name="Nadege Bidan" userId="101290c6-d7fd-4e4f-abb4-82cb3a45689d" providerId="ADAL" clId="{70D8F673-FB0B-4B6C-B731-75A26EEC2BB5}" dt="2022-12-15T09:23:37.251" v="429" actId="478"/>
          <ac:spMkLst>
            <pc:docMk/>
            <pc:sldMk cId="677841024" sldId="256"/>
            <ac:spMk id="15" creationId="{FAA07650-1E13-427B-FDFE-D54E5D26ECD5}"/>
          </ac:spMkLst>
        </pc:spChg>
        <pc:spChg chg="del mod topLvl">
          <ac:chgData name="Nadege Bidan" userId="101290c6-d7fd-4e4f-abb4-82cb3a45689d" providerId="ADAL" clId="{70D8F673-FB0B-4B6C-B731-75A26EEC2BB5}" dt="2022-12-15T09:23:37.251" v="429" actId="478"/>
          <ac:spMkLst>
            <pc:docMk/>
            <pc:sldMk cId="677841024" sldId="256"/>
            <ac:spMk id="16" creationId="{78C2A441-547C-4C8B-89EF-AF3431778E2F}"/>
          </ac:spMkLst>
        </pc:spChg>
        <pc:spChg chg="del mod topLvl">
          <ac:chgData name="Nadege Bidan" userId="101290c6-d7fd-4e4f-abb4-82cb3a45689d" providerId="ADAL" clId="{70D8F673-FB0B-4B6C-B731-75A26EEC2BB5}" dt="2022-12-15T09:23:37.251" v="429" actId="478"/>
          <ac:spMkLst>
            <pc:docMk/>
            <pc:sldMk cId="677841024" sldId="256"/>
            <ac:spMk id="17" creationId="{B5403921-314D-8C60-3BCE-A04A157B9FA5}"/>
          </ac:spMkLst>
        </pc:spChg>
        <pc:spChg chg="mod topLvl">
          <ac:chgData name="Nadege Bidan" userId="101290c6-d7fd-4e4f-abb4-82cb3a45689d" providerId="ADAL" clId="{70D8F673-FB0B-4B6C-B731-75A26EEC2BB5}" dt="2022-12-15T09:23:52.649" v="431" actId="164"/>
          <ac:spMkLst>
            <pc:docMk/>
            <pc:sldMk cId="677841024" sldId="256"/>
            <ac:spMk id="22" creationId="{A3CD2EFF-9118-F12F-2AED-1D75171A27B3}"/>
          </ac:spMkLst>
        </pc:spChg>
        <pc:spChg chg="mod topLvl">
          <ac:chgData name="Nadege Bidan" userId="101290c6-d7fd-4e4f-abb4-82cb3a45689d" providerId="ADAL" clId="{70D8F673-FB0B-4B6C-B731-75A26EEC2BB5}" dt="2022-12-15T09:23:52.649" v="431" actId="164"/>
          <ac:spMkLst>
            <pc:docMk/>
            <pc:sldMk cId="677841024" sldId="256"/>
            <ac:spMk id="23" creationId="{394CFC78-0AC8-94DB-99BA-173E13B5A417}"/>
          </ac:spMkLst>
        </pc:spChg>
        <pc:spChg chg="mod topLvl">
          <ac:chgData name="Nadege Bidan" userId="101290c6-d7fd-4e4f-abb4-82cb3a45689d" providerId="ADAL" clId="{70D8F673-FB0B-4B6C-B731-75A26EEC2BB5}" dt="2022-12-15T09:23:52.649" v="431" actId="164"/>
          <ac:spMkLst>
            <pc:docMk/>
            <pc:sldMk cId="677841024" sldId="256"/>
            <ac:spMk id="24" creationId="{7590BD8F-7E42-EE4C-9A7D-99376EABB6D8}"/>
          </ac:spMkLst>
        </pc:spChg>
        <pc:spChg chg="mod topLvl">
          <ac:chgData name="Nadege Bidan" userId="101290c6-d7fd-4e4f-abb4-82cb3a45689d" providerId="ADAL" clId="{70D8F673-FB0B-4B6C-B731-75A26EEC2BB5}" dt="2022-12-15T09:23:52.649" v="431" actId="164"/>
          <ac:spMkLst>
            <pc:docMk/>
            <pc:sldMk cId="677841024" sldId="256"/>
            <ac:spMk id="25" creationId="{983CBDC5-13CB-0FCA-3189-36218AC970DB}"/>
          </ac:spMkLst>
        </pc:spChg>
        <pc:spChg chg="mod topLvl">
          <ac:chgData name="Nadege Bidan" userId="101290c6-d7fd-4e4f-abb4-82cb3a45689d" providerId="ADAL" clId="{70D8F673-FB0B-4B6C-B731-75A26EEC2BB5}" dt="2022-12-15T09:23:52.649" v="431" actId="164"/>
          <ac:spMkLst>
            <pc:docMk/>
            <pc:sldMk cId="677841024" sldId="256"/>
            <ac:spMk id="26" creationId="{437F8D79-9E0C-FEF7-B298-51B4494F1029}"/>
          </ac:spMkLst>
        </pc:spChg>
        <pc:spChg chg="mod topLvl">
          <ac:chgData name="Nadege Bidan" userId="101290c6-d7fd-4e4f-abb4-82cb3a45689d" providerId="ADAL" clId="{70D8F673-FB0B-4B6C-B731-75A26EEC2BB5}" dt="2022-12-15T09:23:52.649" v="431" actId="164"/>
          <ac:spMkLst>
            <pc:docMk/>
            <pc:sldMk cId="677841024" sldId="256"/>
            <ac:spMk id="27" creationId="{23956117-A97A-C36A-7503-F49DAE575086}"/>
          </ac:spMkLst>
        </pc:spChg>
        <pc:spChg chg="mod">
          <ac:chgData name="Nadege Bidan" userId="101290c6-d7fd-4e4f-abb4-82cb3a45689d" providerId="ADAL" clId="{70D8F673-FB0B-4B6C-B731-75A26EEC2BB5}" dt="2022-12-15T08:57:17.736" v="34"/>
          <ac:spMkLst>
            <pc:docMk/>
            <pc:sldMk cId="677841024" sldId="256"/>
            <ac:spMk id="35" creationId="{382D1BEE-3D20-EE14-F4F9-5EC6FFBA0F68}"/>
          </ac:spMkLst>
        </pc:spChg>
        <pc:spChg chg="mod">
          <ac:chgData name="Nadege Bidan" userId="101290c6-d7fd-4e4f-abb4-82cb3a45689d" providerId="ADAL" clId="{70D8F673-FB0B-4B6C-B731-75A26EEC2BB5}" dt="2022-12-15T08:57:17.736" v="34"/>
          <ac:spMkLst>
            <pc:docMk/>
            <pc:sldMk cId="677841024" sldId="256"/>
            <ac:spMk id="36" creationId="{48B2E379-F266-96E7-C2DE-7666A15A03E0}"/>
          </ac:spMkLst>
        </pc:spChg>
        <pc:spChg chg="mod">
          <ac:chgData name="Nadege Bidan" userId="101290c6-d7fd-4e4f-abb4-82cb3a45689d" providerId="ADAL" clId="{70D8F673-FB0B-4B6C-B731-75A26EEC2BB5}" dt="2022-12-15T08:57:17.736" v="34"/>
          <ac:spMkLst>
            <pc:docMk/>
            <pc:sldMk cId="677841024" sldId="256"/>
            <ac:spMk id="37" creationId="{5FAD2650-23CD-65BE-4BA6-346FD2D56DA0}"/>
          </ac:spMkLst>
        </pc:spChg>
        <pc:spChg chg="mod">
          <ac:chgData name="Nadege Bidan" userId="101290c6-d7fd-4e4f-abb4-82cb3a45689d" providerId="ADAL" clId="{70D8F673-FB0B-4B6C-B731-75A26EEC2BB5}" dt="2022-12-15T08:57:17.736" v="34"/>
          <ac:spMkLst>
            <pc:docMk/>
            <pc:sldMk cId="677841024" sldId="256"/>
            <ac:spMk id="38" creationId="{5ED155BF-7A3C-8233-764B-0A7CD572043B}"/>
          </ac:spMkLst>
        </pc:spChg>
        <pc:spChg chg="mod">
          <ac:chgData name="Nadege Bidan" userId="101290c6-d7fd-4e4f-abb4-82cb3a45689d" providerId="ADAL" clId="{70D8F673-FB0B-4B6C-B731-75A26EEC2BB5}" dt="2022-12-15T08:57:17.736" v="34"/>
          <ac:spMkLst>
            <pc:docMk/>
            <pc:sldMk cId="677841024" sldId="256"/>
            <ac:spMk id="39" creationId="{BFC1D4A5-32F7-FF0D-99EC-EF5C8A124971}"/>
          </ac:spMkLst>
        </pc:spChg>
        <pc:spChg chg="mod">
          <ac:chgData name="Nadege Bidan" userId="101290c6-d7fd-4e4f-abb4-82cb3a45689d" providerId="ADAL" clId="{70D8F673-FB0B-4B6C-B731-75A26EEC2BB5}" dt="2022-12-15T08:57:17.736" v="34"/>
          <ac:spMkLst>
            <pc:docMk/>
            <pc:sldMk cId="677841024" sldId="256"/>
            <ac:spMk id="40" creationId="{4965BE41-0837-1459-0C4C-A8AECE8B330D}"/>
          </ac:spMkLst>
        </pc:spChg>
        <pc:spChg chg="mod">
          <ac:chgData name="Nadege Bidan" userId="101290c6-d7fd-4e4f-abb4-82cb3a45689d" providerId="ADAL" clId="{70D8F673-FB0B-4B6C-B731-75A26EEC2BB5}" dt="2022-12-15T08:57:17.736" v="34"/>
          <ac:spMkLst>
            <pc:docMk/>
            <pc:sldMk cId="677841024" sldId="256"/>
            <ac:spMk id="45" creationId="{7897A919-FA58-ECC2-BAE4-AC7B9AD4A935}"/>
          </ac:spMkLst>
        </pc:spChg>
        <pc:spChg chg="mod">
          <ac:chgData name="Nadege Bidan" userId="101290c6-d7fd-4e4f-abb4-82cb3a45689d" providerId="ADAL" clId="{70D8F673-FB0B-4B6C-B731-75A26EEC2BB5}" dt="2022-12-15T08:57:17.736" v="34"/>
          <ac:spMkLst>
            <pc:docMk/>
            <pc:sldMk cId="677841024" sldId="256"/>
            <ac:spMk id="46" creationId="{1CAE1E45-3308-E122-9315-1D2B7AF05C0A}"/>
          </ac:spMkLst>
        </pc:spChg>
        <pc:spChg chg="mod">
          <ac:chgData name="Nadege Bidan" userId="101290c6-d7fd-4e4f-abb4-82cb3a45689d" providerId="ADAL" clId="{70D8F673-FB0B-4B6C-B731-75A26EEC2BB5}" dt="2022-12-15T08:57:17.736" v="34"/>
          <ac:spMkLst>
            <pc:docMk/>
            <pc:sldMk cId="677841024" sldId="256"/>
            <ac:spMk id="47" creationId="{4B03A062-B898-4843-6ACF-98A0822608D3}"/>
          </ac:spMkLst>
        </pc:spChg>
        <pc:spChg chg="mod">
          <ac:chgData name="Nadege Bidan" userId="101290c6-d7fd-4e4f-abb4-82cb3a45689d" providerId="ADAL" clId="{70D8F673-FB0B-4B6C-B731-75A26EEC2BB5}" dt="2022-12-15T08:57:17.736" v="34"/>
          <ac:spMkLst>
            <pc:docMk/>
            <pc:sldMk cId="677841024" sldId="256"/>
            <ac:spMk id="48" creationId="{52E7FCC7-6F73-BBEE-39EA-CB2D88F8DA73}"/>
          </ac:spMkLst>
        </pc:spChg>
        <pc:spChg chg="mod">
          <ac:chgData name="Nadege Bidan" userId="101290c6-d7fd-4e4f-abb4-82cb3a45689d" providerId="ADAL" clId="{70D8F673-FB0B-4B6C-B731-75A26EEC2BB5}" dt="2022-12-15T08:57:17.736" v="34"/>
          <ac:spMkLst>
            <pc:docMk/>
            <pc:sldMk cId="677841024" sldId="256"/>
            <ac:spMk id="49" creationId="{3A4D4147-59C7-A76A-018A-5F15CFB2C0C6}"/>
          </ac:spMkLst>
        </pc:spChg>
        <pc:spChg chg="mod">
          <ac:chgData name="Nadege Bidan" userId="101290c6-d7fd-4e4f-abb4-82cb3a45689d" providerId="ADAL" clId="{70D8F673-FB0B-4B6C-B731-75A26EEC2BB5}" dt="2022-12-15T08:57:17.736" v="34"/>
          <ac:spMkLst>
            <pc:docMk/>
            <pc:sldMk cId="677841024" sldId="256"/>
            <ac:spMk id="50" creationId="{8510EFC8-60A4-CB18-5A47-571AD806BBA7}"/>
          </ac:spMkLst>
        </pc:spChg>
        <pc:spChg chg="add del mod">
          <ac:chgData name="Nadege Bidan" userId="101290c6-d7fd-4e4f-abb4-82cb3a45689d" providerId="ADAL" clId="{70D8F673-FB0B-4B6C-B731-75A26EEC2BB5}" dt="2022-12-15T09:05:16.162" v="142"/>
          <ac:spMkLst>
            <pc:docMk/>
            <pc:sldMk cId="677841024" sldId="256"/>
            <ac:spMk id="53" creationId="{240B07D7-1406-B178-A4CE-43B05F865966}"/>
          </ac:spMkLst>
        </pc:spChg>
        <pc:spChg chg="add del mod">
          <ac:chgData name="Nadege Bidan" userId="101290c6-d7fd-4e4f-abb4-82cb3a45689d" providerId="ADAL" clId="{70D8F673-FB0B-4B6C-B731-75A26EEC2BB5}" dt="2022-12-15T09:05:16.163" v="144"/>
          <ac:spMkLst>
            <pc:docMk/>
            <pc:sldMk cId="677841024" sldId="256"/>
            <ac:spMk id="54" creationId="{C7BE29D7-CD8B-08FC-0C69-D6DBE5D92508}"/>
          </ac:spMkLst>
        </pc:spChg>
        <pc:spChg chg="add mod">
          <ac:chgData name="Nadege Bidan" userId="101290c6-d7fd-4e4f-abb4-82cb3a45689d" providerId="ADAL" clId="{70D8F673-FB0B-4B6C-B731-75A26EEC2BB5}" dt="2022-12-15T09:15:05.690" v="292" actId="164"/>
          <ac:spMkLst>
            <pc:docMk/>
            <pc:sldMk cId="677841024" sldId="256"/>
            <ac:spMk id="55" creationId="{3032F5D5-0BE6-7DE7-6CC4-8677F352EEB3}"/>
          </ac:spMkLst>
        </pc:spChg>
        <pc:spChg chg="add mod">
          <ac:chgData name="Nadege Bidan" userId="101290c6-d7fd-4e4f-abb4-82cb3a45689d" providerId="ADAL" clId="{70D8F673-FB0B-4B6C-B731-75A26EEC2BB5}" dt="2022-12-15T09:15:05.690" v="292" actId="164"/>
          <ac:spMkLst>
            <pc:docMk/>
            <pc:sldMk cId="677841024" sldId="256"/>
            <ac:spMk id="56" creationId="{6B6036EC-A68B-976A-FABA-C1834BFF7540}"/>
          </ac:spMkLst>
        </pc:spChg>
        <pc:spChg chg="add mod">
          <ac:chgData name="Nadege Bidan" userId="101290c6-d7fd-4e4f-abb4-82cb3a45689d" providerId="ADAL" clId="{70D8F673-FB0B-4B6C-B731-75A26EEC2BB5}" dt="2022-12-15T09:15:05.690" v="292" actId="164"/>
          <ac:spMkLst>
            <pc:docMk/>
            <pc:sldMk cId="677841024" sldId="256"/>
            <ac:spMk id="57" creationId="{58C17915-DA76-B84A-3A93-B1F1944DD485}"/>
          </ac:spMkLst>
        </pc:spChg>
        <pc:spChg chg="add mod">
          <ac:chgData name="Nadege Bidan" userId="101290c6-d7fd-4e4f-abb4-82cb3a45689d" providerId="ADAL" clId="{70D8F673-FB0B-4B6C-B731-75A26EEC2BB5}" dt="2022-12-15T09:15:05.690" v="292" actId="164"/>
          <ac:spMkLst>
            <pc:docMk/>
            <pc:sldMk cId="677841024" sldId="256"/>
            <ac:spMk id="58" creationId="{CADF853E-2F00-61D0-4EB9-DED642941665}"/>
          </ac:spMkLst>
        </pc:spChg>
        <pc:spChg chg="add mod">
          <ac:chgData name="Nadege Bidan" userId="101290c6-d7fd-4e4f-abb4-82cb3a45689d" providerId="ADAL" clId="{70D8F673-FB0B-4B6C-B731-75A26EEC2BB5}" dt="2022-12-15T09:15:05.690" v="292" actId="164"/>
          <ac:spMkLst>
            <pc:docMk/>
            <pc:sldMk cId="677841024" sldId="256"/>
            <ac:spMk id="59" creationId="{0E3E7B5D-682E-023B-E212-750DC4680BB1}"/>
          </ac:spMkLst>
        </pc:spChg>
        <pc:spChg chg="add mod">
          <ac:chgData name="Nadege Bidan" userId="101290c6-d7fd-4e4f-abb4-82cb3a45689d" providerId="ADAL" clId="{70D8F673-FB0B-4B6C-B731-75A26EEC2BB5}" dt="2022-12-15T09:15:05.690" v="292" actId="164"/>
          <ac:spMkLst>
            <pc:docMk/>
            <pc:sldMk cId="677841024" sldId="256"/>
            <ac:spMk id="60" creationId="{40435044-687B-7122-7F2B-B150084AD442}"/>
          </ac:spMkLst>
        </pc:spChg>
        <pc:spChg chg="mod">
          <ac:chgData name="Nadege Bidan" userId="101290c6-d7fd-4e4f-abb4-82cb3a45689d" providerId="ADAL" clId="{70D8F673-FB0B-4B6C-B731-75A26EEC2BB5}" dt="2022-12-15T09:15:17.113" v="294"/>
          <ac:spMkLst>
            <pc:docMk/>
            <pc:sldMk cId="677841024" sldId="256"/>
            <ac:spMk id="63" creationId="{B38FD1AD-F6F5-A325-1A63-96F52AE03E6A}"/>
          </ac:spMkLst>
        </pc:spChg>
        <pc:spChg chg="mod">
          <ac:chgData name="Nadege Bidan" userId="101290c6-d7fd-4e4f-abb4-82cb3a45689d" providerId="ADAL" clId="{70D8F673-FB0B-4B6C-B731-75A26EEC2BB5}" dt="2022-12-15T09:15:17.113" v="294"/>
          <ac:spMkLst>
            <pc:docMk/>
            <pc:sldMk cId="677841024" sldId="256"/>
            <ac:spMk id="64" creationId="{BCB9D24B-E780-ED44-C3AF-02C37CF609F9}"/>
          </ac:spMkLst>
        </pc:spChg>
        <pc:spChg chg="mod">
          <ac:chgData name="Nadege Bidan" userId="101290c6-d7fd-4e4f-abb4-82cb3a45689d" providerId="ADAL" clId="{70D8F673-FB0B-4B6C-B731-75A26EEC2BB5}" dt="2022-12-15T09:15:17.113" v="294"/>
          <ac:spMkLst>
            <pc:docMk/>
            <pc:sldMk cId="677841024" sldId="256"/>
            <ac:spMk id="65" creationId="{A0A084DD-CDAD-36ED-40AF-A65B01739653}"/>
          </ac:spMkLst>
        </pc:spChg>
        <pc:spChg chg="mod">
          <ac:chgData name="Nadege Bidan" userId="101290c6-d7fd-4e4f-abb4-82cb3a45689d" providerId="ADAL" clId="{70D8F673-FB0B-4B6C-B731-75A26EEC2BB5}" dt="2022-12-15T09:15:17.113" v="294"/>
          <ac:spMkLst>
            <pc:docMk/>
            <pc:sldMk cId="677841024" sldId="256"/>
            <ac:spMk id="66" creationId="{4E0113B3-5C4E-AB0F-74C6-C6D0CAE8F632}"/>
          </ac:spMkLst>
        </pc:spChg>
        <pc:spChg chg="mod">
          <ac:chgData name="Nadege Bidan" userId="101290c6-d7fd-4e4f-abb4-82cb3a45689d" providerId="ADAL" clId="{70D8F673-FB0B-4B6C-B731-75A26EEC2BB5}" dt="2022-12-15T09:15:17.113" v="294"/>
          <ac:spMkLst>
            <pc:docMk/>
            <pc:sldMk cId="677841024" sldId="256"/>
            <ac:spMk id="67" creationId="{48F713C5-CDCD-5360-9CA3-366BEA8EB595}"/>
          </ac:spMkLst>
        </pc:spChg>
        <pc:spChg chg="mod">
          <ac:chgData name="Nadege Bidan" userId="101290c6-d7fd-4e4f-abb4-82cb3a45689d" providerId="ADAL" clId="{70D8F673-FB0B-4B6C-B731-75A26EEC2BB5}" dt="2022-12-15T09:15:17.113" v="294"/>
          <ac:spMkLst>
            <pc:docMk/>
            <pc:sldMk cId="677841024" sldId="256"/>
            <ac:spMk id="68" creationId="{A1ADBC08-558D-C5D2-BC09-0F85B41715C8}"/>
          </ac:spMkLst>
        </pc:spChg>
        <pc:spChg chg="mod">
          <ac:chgData name="Nadege Bidan" userId="101290c6-d7fd-4e4f-abb4-82cb3a45689d" providerId="ADAL" clId="{70D8F673-FB0B-4B6C-B731-75A26EEC2BB5}" dt="2022-12-15T09:15:58.859" v="309"/>
          <ac:spMkLst>
            <pc:docMk/>
            <pc:sldMk cId="677841024" sldId="256"/>
            <ac:spMk id="70" creationId="{A8B29B84-9C35-10ED-97E2-37731F62251A}"/>
          </ac:spMkLst>
        </pc:spChg>
        <pc:spChg chg="mod">
          <ac:chgData name="Nadege Bidan" userId="101290c6-d7fd-4e4f-abb4-82cb3a45689d" providerId="ADAL" clId="{70D8F673-FB0B-4B6C-B731-75A26EEC2BB5}" dt="2022-12-15T09:15:58.859" v="309"/>
          <ac:spMkLst>
            <pc:docMk/>
            <pc:sldMk cId="677841024" sldId="256"/>
            <ac:spMk id="71" creationId="{4E564FFF-F622-6041-2F75-F59DBD871F75}"/>
          </ac:spMkLst>
        </pc:spChg>
        <pc:spChg chg="mod">
          <ac:chgData name="Nadege Bidan" userId="101290c6-d7fd-4e4f-abb4-82cb3a45689d" providerId="ADAL" clId="{70D8F673-FB0B-4B6C-B731-75A26EEC2BB5}" dt="2022-12-15T09:15:58.859" v="309"/>
          <ac:spMkLst>
            <pc:docMk/>
            <pc:sldMk cId="677841024" sldId="256"/>
            <ac:spMk id="72" creationId="{FCE30D06-0060-FFA2-4D48-5E3E5B9F674D}"/>
          </ac:spMkLst>
        </pc:spChg>
        <pc:spChg chg="mod">
          <ac:chgData name="Nadege Bidan" userId="101290c6-d7fd-4e4f-abb4-82cb3a45689d" providerId="ADAL" clId="{70D8F673-FB0B-4B6C-B731-75A26EEC2BB5}" dt="2022-12-15T09:15:58.859" v="309"/>
          <ac:spMkLst>
            <pc:docMk/>
            <pc:sldMk cId="677841024" sldId="256"/>
            <ac:spMk id="73" creationId="{88F4FDF7-0A72-1F16-5CEA-CA946669D6F7}"/>
          </ac:spMkLst>
        </pc:spChg>
        <pc:spChg chg="mod">
          <ac:chgData name="Nadege Bidan" userId="101290c6-d7fd-4e4f-abb4-82cb3a45689d" providerId="ADAL" clId="{70D8F673-FB0B-4B6C-B731-75A26EEC2BB5}" dt="2022-12-15T09:15:58.859" v="309"/>
          <ac:spMkLst>
            <pc:docMk/>
            <pc:sldMk cId="677841024" sldId="256"/>
            <ac:spMk id="74" creationId="{386A4593-6266-FF12-E995-6195F094A37B}"/>
          </ac:spMkLst>
        </pc:spChg>
        <pc:spChg chg="mod">
          <ac:chgData name="Nadege Bidan" userId="101290c6-d7fd-4e4f-abb4-82cb3a45689d" providerId="ADAL" clId="{70D8F673-FB0B-4B6C-B731-75A26EEC2BB5}" dt="2022-12-15T09:15:58.859" v="309"/>
          <ac:spMkLst>
            <pc:docMk/>
            <pc:sldMk cId="677841024" sldId="256"/>
            <ac:spMk id="75" creationId="{3BFB2C8A-71D3-B115-79B7-66915542125A}"/>
          </ac:spMkLst>
        </pc:spChg>
        <pc:spChg chg="add mod">
          <ac:chgData name="Nadege Bidan" userId="101290c6-d7fd-4e4f-abb4-82cb3a45689d" providerId="ADAL" clId="{70D8F673-FB0B-4B6C-B731-75A26EEC2BB5}" dt="2022-12-15T09:23:52.649" v="431" actId="164"/>
          <ac:spMkLst>
            <pc:docMk/>
            <pc:sldMk cId="677841024" sldId="256"/>
            <ac:spMk id="76" creationId="{BD4E4FF7-EE4B-526A-4351-DCB4BE964BC0}"/>
          </ac:spMkLst>
        </pc:spChg>
        <pc:spChg chg="add mod">
          <ac:chgData name="Nadege Bidan" userId="101290c6-d7fd-4e4f-abb4-82cb3a45689d" providerId="ADAL" clId="{70D8F673-FB0B-4B6C-B731-75A26EEC2BB5}" dt="2022-12-15T09:23:52.649" v="431" actId="164"/>
          <ac:spMkLst>
            <pc:docMk/>
            <pc:sldMk cId="677841024" sldId="256"/>
            <ac:spMk id="77" creationId="{CCBBA386-5F72-853B-353C-1648AC79B47E}"/>
          </ac:spMkLst>
        </pc:spChg>
        <pc:spChg chg="add mod">
          <ac:chgData name="Nadege Bidan" userId="101290c6-d7fd-4e4f-abb4-82cb3a45689d" providerId="ADAL" clId="{70D8F673-FB0B-4B6C-B731-75A26EEC2BB5}" dt="2022-12-15T09:23:52.649" v="431" actId="164"/>
          <ac:spMkLst>
            <pc:docMk/>
            <pc:sldMk cId="677841024" sldId="256"/>
            <ac:spMk id="78" creationId="{5337C063-4790-A93A-1A44-26F1D7A14BE8}"/>
          </ac:spMkLst>
        </pc:spChg>
        <pc:spChg chg="add mod">
          <ac:chgData name="Nadege Bidan" userId="101290c6-d7fd-4e4f-abb4-82cb3a45689d" providerId="ADAL" clId="{70D8F673-FB0B-4B6C-B731-75A26EEC2BB5}" dt="2022-12-15T09:23:52.649" v="431" actId="164"/>
          <ac:spMkLst>
            <pc:docMk/>
            <pc:sldMk cId="677841024" sldId="256"/>
            <ac:spMk id="79" creationId="{1EB5CA05-0A33-9047-6E02-159FCAB560FC}"/>
          </ac:spMkLst>
        </pc:spChg>
        <pc:spChg chg="add mod">
          <ac:chgData name="Nadege Bidan" userId="101290c6-d7fd-4e4f-abb4-82cb3a45689d" providerId="ADAL" clId="{70D8F673-FB0B-4B6C-B731-75A26EEC2BB5}" dt="2022-12-15T09:23:52.649" v="431" actId="164"/>
          <ac:spMkLst>
            <pc:docMk/>
            <pc:sldMk cId="677841024" sldId="256"/>
            <ac:spMk id="80" creationId="{795EE4A7-0B87-1DFF-1948-3E750549714A}"/>
          </ac:spMkLst>
        </pc:spChg>
        <pc:spChg chg="add mod">
          <ac:chgData name="Nadege Bidan" userId="101290c6-d7fd-4e4f-abb4-82cb3a45689d" providerId="ADAL" clId="{70D8F673-FB0B-4B6C-B731-75A26EEC2BB5}" dt="2022-12-15T09:23:52.649" v="431" actId="164"/>
          <ac:spMkLst>
            <pc:docMk/>
            <pc:sldMk cId="677841024" sldId="256"/>
            <ac:spMk id="81" creationId="{2DC3C10F-A37A-8DB6-3BE9-64A5850A9FAF}"/>
          </ac:spMkLst>
        </pc:spChg>
        <pc:spChg chg="add mod">
          <ac:chgData name="Nadege Bidan" userId="101290c6-d7fd-4e4f-abb4-82cb3a45689d" providerId="ADAL" clId="{70D8F673-FB0B-4B6C-B731-75A26EEC2BB5}" dt="2022-12-15T09:23:52.649" v="431" actId="164"/>
          <ac:spMkLst>
            <pc:docMk/>
            <pc:sldMk cId="677841024" sldId="256"/>
            <ac:spMk id="82" creationId="{A6F1F30E-BD3E-4B73-C7C2-68A03A96D839}"/>
          </ac:spMkLst>
        </pc:spChg>
        <pc:spChg chg="add mod">
          <ac:chgData name="Nadege Bidan" userId="101290c6-d7fd-4e4f-abb4-82cb3a45689d" providerId="ADAL" clId="{70D8F673-FB0B-4B6C-B731-75A26EEC2BB5}" dt="2022-12-15T09:23:52.649" v="431" actId="164"/>
          <ac:spMkLst>
            <pc:docMk/>
            <pc:sldMk cId="677841024" sldId="256"/>
            <ac:spMk id="83" creationId="{3154FD4E-4FD1-2E68-85FD-8A27BB611930}"/>
          </ac:spMkLst>
        </pc:spChg>
        <pc:spChg chg="add mod">
          <ac:chgData name="Nadege Bidan" userId="101290c6-d7fd-4e4f-abb4-82cb3a45689d" providerId="ADAL" clId="{70D8F673-FB0B-4B6C-B731-75A26EEC2BB5}" dt="2022-12-15T09:23:52.649" v="431" actId="164"/>
          <ac:spMkLst>
            <pc:docMk/>
            <pc:sldMk cId="677841024" sldId="256"/>
            <ac:spMk id="84" creationId="{39838195-7AFC-2CF3-A98E-4B3CBD09CC46}"/>
          </ac:spMkLst>
        </pc:spChg>
        <pc:spChg chg="add mod">
          <ac:chgData name="Nadege Bidan" userId="101290c6-d7fd-4e4f-abb4-82cb3a45689d" providerId="ADAL" clId="{70D8F673-FB0B-4B6C-B731-75A26EEC2BB5}" dt="2022-12-15T09:23:52.649" v="431" actId="164"/>
          <ac:spMkLst>
            <pc:docMk/>
            <pc:sldMk cId="677841024" sldId="256"/>
            <ac:spMk id="85" creationId="{F497A063-6EA5-3D0C-B9EB-87298D00E6F1}"/>
          </ac:spMkLst>
        </pc:spChg>
        <pc:spChg chg="add mod">
          <ac:chgData name="Nadege Bidan" userId="101290c6-d7fd-4e4f-abb4-82cb3a45689d" providerId="ADAL" clId="{70D8F673-FB0B-4B6C-B731-75A26EEC2BB5}" dt="2022-12-15T10:14:17.030" v="802" actId="1036"/>
          <ac:spMkLst>
            <pc:docMk/>
            <pc:sldMk cId="677841024" sldId="256"/>
            <ac:spMk id="87" creationId="{6CD8B660-A682-1532-7775-8F1D6938170C}"/>
          </ac:spMkLst>
        </pc:spChg>
        <pc:spChg chg="add del mod topLvl">
          <ac:chgData name="Nadege Bidan" userId="101290c6-d7fd-4e4f-abb4-82cb3a45689d" providerId="ADAL" clId="{70D8F673-FB0B-4B6C-B731-75A26EEC2BB5}" dt="2022-12-21T11:20:16.987" v="1031" actId="478"/>
          <ac:spMkLst>
            <pc:docMk/>
            <pc:sldMk cId="677841024" sldId="256"/>
            <ac:spMk id="88" creationId="{B22445F1-2DDD-3F9F-C19E-ADB82BAB6038}"/>
          </ac:spMkLst>
        </pc:spChg>
        <pc:spChg chg="add del mod topLvl">
          <ac:chgData name="Nadege Bidan" userId="101290c6-d7fd-4e4f-abb4-82cb3a45689d" providerId="ADAL" clId="{70D8F673-FB0B-4B6C-B731-75A26EEC2BB5}" dt="2022-12-21T16:07:29.886" v="1145" actId="478"/>
          <ac:spMkLst>
            <pc:docMk/>
            <pc:sldMk cId="677841024" sldId="256"/>
            <ac:spMk id="89" creationId="{8CA5925F-033E-932C-FB63-935E7A79EB5B}"/>
          </ac:spMkLst>
        </pc:spChg>
        <pc:spChg chg="add mod topLvl">
          <ac:chgData name="Nadege Bidan" userId="101290c6-d7fd-4e4f-abb4-82cb3a45689d" providerId="ADAL" clId="{70D8F673-FB0B-4B6C-B731-75A26EEC2BB5}" dt="2022-12-21T16:10:45.382" v="1265" actId="1036"/>
          <ac:spMkLst>
            <pc:docMk/>
            <pc:sldMk cId="677841024" sldId="256"/>
            <ac:spMk id="90" creationId="{94A21F0C-637A-03A6-968E-6952D0147BB3}"/>
          </ac:spMkLst>
        </pc:spChg>
        <pc:spChg chg="add mod">
          <ac:chgData name="Nadege Bidan" userId="101290c6-d7fd-4e4f-abb4-82cb3a45689d" providerId="ADAL" clId="{70D8F673-FB0B-4B6C-B731-75A26EEC2BB5}" dt="2022-12-21T16:10:31.700" v="1242" actId="115"/>
          <ac:spMkLst>
            <pc:docMk/>
            <pc:sldMk cId="677841024" sldId="256"/>
            <ac:spMk id="101" creationId="{946DBEDC-ABA7-63E3-F5D7-041CDB725434}"/>
          </ac:spMkLst>
        </pc:spChg>
        <pc:spChg chg="add mod">
          <ac:chgData name="Nadege Bidan" userId="101290c6-d7fd-4e4f-abb4-82cb3a45689d" providerId="ADAL" clId="{70D8F673-FB0B-4B6C-B731-75A26EEC2BB5}" dt="2022-12-21T16:08:26.832" v="1160" actId="164"/>
          <ac:spMkLst>
            <pc:docMk/>
            <pc:sldMk cId="677841024" sldId="256"/>
            <ac:spMk id="102" creationId="{361861FD-F844-1633-C99B-32CACD03D201}"/>
          </ac:spMkLst>
        </pc:spChg>
        <pc:spChg chg="add mod">
          <ac:chgData name="Nadege Bidan" userId="101290c6-d7fd-4e4f-abb4-82cb3a45689d" providerId="ADAL" clId="{70D8F673-FB0B-4B6C-B731-75A26EEC2BB5}" dt="2022-12-21T16:08:26.832" v="1160" actId="164"/>
          <ac:spMkLst>
            <pc:docMk/>
            <pc:sldMk cId="677841024" sldId="256"/>
            <ac:spMk id="103" creationId="{A1EC6742-041D-0231-0CD6-61A7C34DC6D7}"/>
          </ac:spMkLst>
        </pc:spChg>
        <pc:spChg chg="add mod">
          <ac:chgData name="Nadege Bidan" userId="101290c6-d7fd-4e4f-abb4-82cb3a45689d" providerId="ADAL" clId="{70D8F673-FB0B-4B6C-B731-75A26EEC2BB5}" dt="2022-12-21T16:08:26.832" v="1160" actId="164"/>
          <ac:spMkLst>
            <pc:docMk/>
            <pc:sldMk cId="677841024" sldId="256"/>
            <ac:spMk id="104" creationId="{3B3F6148-86F9-B502-BAA6-1389F4DA76AE}"/>
          </ac:spMkLst>
        </pc:spChg>
        <pc:spChg chg="add mod">
          <ac:chgData name="Nadege Bidan" userId="101290c6-d7fd-4e4f-abb4-82cb3a45689d" providerId="ADAL" clId="{70D8F673-FB0B-4B6C-B731-75A26EEC2BB5}" dt="2022-12-21T16:10:04.150" v="1237" actId="164"/>
          <ac:spMkLst>
            <pc:docMk/>
            <pc:sldMk cId="677841024" sldId="256"/>
            <ac:spMk id="105" creationId="{AEB889F7-49FB-591E-FB97-FF9FA1FCD0C0}"/>
          </ac:spMkLst>
        </pc:spChg>
        <pc:spChg chg="add mod">
          <ac:chgData name="Nadege Bidan" userId="101290c6-d7fd-4e4f-abb4-82cb3a45689d" providerId="ADAL" clId="{70D8F673-FB0B-4B6C-B731-75A26EEC2BB5}" dt="2022-12-21T16:10:04.150" v="1237" actId="164"/>
          <ac:spMkLst>
            <pc:docMk/>
            <pc:sldMk cId="677841024" sldId="256"/>
            <ac:spMk id="106" creationId="{E1D4D8FF-5D7A-71D8-32B9-4E57879CC36B}"/>
          </ac:spMkLst>
        </pc:spChg>
        <pc:spChg chg="add mod">
          <ac:chgData name="Nadege Bidan" userId="101290c6-d7fd-4e4f-abb4-82cb3a45689d" providerId="ADAL" clId="{70D8F673-FB0B-4B6C-B731-75A26EEC2BB5}" dt="2022-12-21T16:10:04.150" v="1237" actId="164"/>
          <ac:spMkLst>
            <pc:docMk/>
            <pc:sldMk cId="677841024" sldId="256"/>
            <ac:spMk id="107" creationId="{1F356596-DB4A-09D8-FD7E-F402C771350B}"/>
          </ac:spMkLst>
        </pc:spChg>
        <pc:spChg chg="add mod">
          <ac:chgData name="Nadege Bidan" userId="101290c6-d7fd-4e4f-abb4-82cb3a45689d" providerId="ADAL" clId="{70D8F673-FB0B-4B6C-B731-75A26EEC2BB5}" dt="2022-12-21T16:10:17.415" v="1239" actId="164"/>
          <ac:spMkLst>
            <pc:docMk/>
            <pc:sldMk cId="677841024" sldId="256"/>
            <ac:spMk id="108" creationId="{07048B84-0211-A3CC-8887-6054823E51DE}"/>
          </ac:spMkLst>
        </pc:spChg>
        <pc:spChg chg="add mod">
          <ac:chgData name="Nadege Bidan" userId="101290c6-d7fd-4e4f-abb4-82cb3a45689d" providerId="ADAL" clId="{70D8F673-FB0B-4B6C-B731-75A26EEC2BB5}" dt="2022-12-21T16:10:17.415" v="1239" actId="164"/>
          <ac:spMkLst>
            <pc:docMk/>
            <pc:sldMk cId="677841024" sldId="256"/>
            <ac:spMk id="109" creationId="{4609674A-3B75-E2CB-7BBB-9EF6E5F5B2D6}"/>
          </ac:spMkLst>
        </pc:spChg>
        <pc:spChg chg="add mod">
          <ac:chgData name="Nadege Bidan" userId="101290c6-d7fd-4e4f-abb4-82cb3a45689d" providerId="ADAL" clId="{70D8F673-FB0B-4B6C-B731-75A26EEC2BB5}" dt="2022-12-21T16:10:17.415" v="1239" actId="164"/>
          <ac:spMkLst>
            <pc:docMk/>
            <pc:sldMk cId="677841024" sldId="256"/>
            <ac:spMk id="110" creationId="{9B6047CD-BE36-C4C4-CA38-A6DF9B3D4225}"/>
          </ac:spMkLst>
        </pc:spChg>
        <pc:grpChg chg="add del mod">
          <ac:chgData name="Nadege Bidan" userId="101290c6-d7fd-4e4f-abb4-82cb3a45689d" providerId="ADAL" clId="{70D8F673-FB0B-4B6C-B731-75A26EEC2BB5}" dt="2022-12-15T08:57:24.201" v="37" actId="165"/>
          <ac:grpSpMkLst>
            <pc:docMk/>
            <pc:sldMk cId="677841024" sldId="256"/>
            <ac:grpSpMk id="5" creationId="{9ECC1224-C1F8-702E-92C6-5BC0803FA602}"/>
          </ac:grpSpMkLst>
        </pc:grpChg>
        <pc:grpChg chg="add mod">
          <ac:chgData name="Nadege Bidan" userId="101290c6-d7fd-4e4f-abb4-82cb3a45689d" providerId="ADAL" clId="{70D8F673-FB0B-4B6C-B731-75A26EEC2BB5}" dt="2022-12-21T16:10:45.382" v="1265" actId="1036"/>
          <ac:grpSpMkLst>
            <pc:docMk/>
            <pc:sldMk cId="677841024" sldId="256"/>
            <ac:grpSpMk id="13" creationId="{6CFBA2CE-064E-7615-AC95-98E3A2664F57}"/>
          </ac:grpSpMkLst>
        </pc:grpChg>
        <pc:grpChg chg="add mod">
          <ac:chgData name="Nadege Bidan" userId="101290c6-d7fd-4e4f-abb4-82cb3a45689d" providerId="ADAL" clId="{70D8F673-FB0B-4B6C-B731-75A26EEC2BB5}" dt="2022-12-21T16:10:38.017" v="1249" actId="1035"/>
          <ac:grpSpMkLst>
            <pc:docMk/>
            <pc:sldMk cId="677841024" sldId="256"/>
            <ac:grpSpMk id="16" creationId="{0AB35D35-8A39-9C67-C093-4CB2E6281395}"/>
          </ac:grpSpMkLst>
        </pc:grpChg>
        <pc:grpChg chg="add mod">
          <ac:chgData name="Nadege Bidan" userId="101290c6-d7fd-4e4f-abb4-82cb3a45689d" providerId="ADAL" clId="{70D8F673-FB0B-4B6C-B731-75A26EEC2BB5}" dt="2022-12-21T16:10:24.506" v="1240" actId="1076"/>
          <ac:grpSpMkLst>
            <pc:docMk/>
            <pc:sldMk cId="677841024" sldId="256"/>
            <ac:grpSpMk id="17" creationId="{0B7C156C-957A-3B2A-801E-CF9AF1AE6428}"/>
          </ac:grpSpMkLst>
        </pc:grpChg>
        <pc:grpChg chg="add del mod">
          <ac:chgData name="Nadege Bidan" userId="101290c6-d7fd-4e4f-abb4-82cb3a45689d" providerId="ADAL" clId="{70D8F673-FB0B-4B6C-B731-75A26EEC2BB5}" dt="2022-12-15T08:57:25.790" v="38" actId="478"/>
          <ac:grpSpMkLst>
            <pc:docMk/>
            <pc:sldMk cId="677841024" sldId="256"/>
            <ac:grpSpMk id="29" creationId="{FF7C60CE-EC20-B6D8-EA62-37AEDA53FA05}"/>
          </ac:grpSpMkLst>
        </pc:grpChg>
        <pc:grpChg chg="add mod">
          <ac:chgData name="Nadege Bidan" userId="101290c6-d7fd-4e4f-abb4-82cb3a45689d" providerId="ADAL" clId="{70D8F673-FB0B-4B6C-B731-75A26EEC2BB5}" dt="2022-12-15T09:23:52.649" v="431" actId="164"/>
          <ac:grpSpMkLst>
            <pc:docMk/>
            <pc:sldMk cId="677841024" sldId="256"/>
            <ac:grpSpMk id="61" creationId="{1C8A42DB-4C6A-D137-2FEB-8194BBC26A3A}"/>
          </ac:grpSpMkLst>
        </pc:grpChg>
        <pc:grpChg chg="add mod">
          <ac:chgData name="Nadege Bidan" userId="101290c6-d7fd-4e4f-abb4-82cb3a45689d" providerId="ADAL" clId="{70D8F673-FB0B-4B6C-B731-75A26EEC2BB5}" dt="2022-12-15T09:23:52.649" v="431" actId="164"/>
          <ac:grpSpMkLst>
            <pc:docMk/>
            <pc:sldMk cId="677841024" sldId="256"/>
            <ac:grpSpMk id="62" creationId="{292D7BC0-38A1-2B99-9106-0D8C49D51DA3}"/>
          </ac:grpSpMkLst>
        </pc:grpChg>
        <pc:grpChg chg="add mod">
          <ac:chgData name="Nadege Bidan" userId="101290c6-d7fd-4e4f-abb4-82cb3a45689d" providerId="ADAL" clId="{70D8F673-FB0B-4B6C-B731-75A26EEC2BB5}" dt="2022-12-15T09:23:52.649" v="431" actId="164"/>
          <ac:grpSpMkLst>
            <pc:docMk/>
            <pc:sldMk cId="677841024" sldId="256"/>
            <ac:grpSpMk id="69" creationId="{B1561466-4BF1-6BDB-CCD5-B30C087586E9}"/>
          </ac:grpSpMkLst>
        </pc:grpChg>
        <pc:grpChg chg="add mod">
          <ac:chgData name="Nadege Bidan" userId="101290c6-d7fd-4e4f-abb4-82cb3a45689d" providerId="ADAL" clId="{70D8F673-FB0B-4B6C-B731-75A26EEC2BB5}" dt="2022-12-15T10:14:22.466" v="808" actId="1036"/>
          <ac:grpSpMkLst>
            <pc:docMk/>
            <pc:sldMk cId="677841024" sldId="256"/>
            <ac:grpSpMk id="86" creationId="{51DF36EA-D9F6-6F75-B6A6-A405A68EC903}"/>
          </ac:grpSpMkLst>
        </pc:grpChg>
        <pc:grpChg chg="add del mod">
          <ac:chgData name="Nadege Bidan" userId="101290c6-d7fd-4e4f-abb4-82cb3a45689d" providerId="ADAL" clId="{70D8F673-FB0B-4B6C-B731-75A26EEC2BB5}" dt="2022-12-15T10:10:32.823" v="727" actId="165"/>
          <ac:grpSpMkLst>
            <pc:docMk/>
            <pc:sldMk cId="677841024" sldId="256"/>
            <ac:grpSpMk id="94" creationId="{0B5FBD11-BFDE-D6E7-F200-AA4BBC1A0368}"/>
          </ac:grpSpMkLst>
        </pc:grpChg>
        <pc:graphicFrameChg chg="add mod ord modGraphic">
          <ac:chgData name="Nadege Bidan" userId="101290c6-d7fd-4e4f-abb4-82cb3a45689d" providerId="ADAL" clId="{70D8F673-FB0B-4B6C-B731-75A26EEC2BB5}" dt="2022-12-21T16:07:25.197" v="1144" actId="167"/>
          <ac:graphicFrameMkLst>
            <pc:docMk/>
            <pc:sldMk cId="677841024" sldId="256"/>
            <ac:graphicFrameMk id="12" creationId="{CFA702B7-190B-4810-6739-0CA2B2291A9E}"/>
          </ac:graphicFrameMkLst>
        </pc:graphicFrameChg>
        <pc:picChg chg="mod topLvl modCrop">
          <ac:chgData name="Nadege Bidan" userId="101290c6-d7fd-4e4f-abb4-82cb3a45689d" providerId="ADAL" clId="{70D8F673-FB0B-4B6C-B731-75A26EEC2BB5}" dt="2022-12-15T09:23:52.649" v="431" actId="164"/>
          <ac:picMkLst>
            <pc:docMk/>
            <pc:sldMk cId="677841024" sldId="256"/>
            <ac:picMk id="6" creationId="{6C6DC1E2-11D5-F7B9-A278-8F314D418F57}"/>
          </ac:picMkLst>
        </pc:picChg>
        <pc:picChg chg="mod topLvl modCrop">
          <ac:chgData name="Nadege Bidan" userId="101290c6-d7fd-4e4f-abb4-82cb3a45689d" providerId="ADAL" clId="{70D8F673-FB0B-4B6C-B731-75A26EEC2BB5}" dt="2022-12-15T09:23:52.649" v="431" actId="164"/>
          <ac:picMkLst>
            <pc:docMk/>
            <pc:sldMk cId="677841024" sldId="256"/>
            <ac:picMk id="7" creationId="{4D3C9438-DFE3-985A-271E-B88BBBBDB279}"/>
          </ac:picMkLst>
        </pc:picChg>
        <pc:picChg chg="mod">
          <ac:chgData name="Nadege Bidan" userId="101290c6-d7fd-4e4f-abb4-82cb3a45689d" providerId="ADAL" clId="{70D8F673-FB0B-4B6C-B731-75A26EEC2BB5}" dt="2022-12-15T10:14:45.073" v="814" actId="14100"/>
          <ac:picMkLst>
            <pc:docMk/>
            <pc:sldMk cId="677841024" sldId="256"/>
            <ac:picMk id="8" creationId="{C90BC3B2-BC7A-90D6-8899-9BD768FDD9D1}"/>
          </ac:picMkLst>
        </pc:picChg>
        <pc:picChg chg="mod topLvl modCrop">
          <ac:chgData name="Nadege Bidan" userId="101290c6-d7fd-4e4f-abb4-82cb3a45689d" providerId="ADAL" clId="{70D8F673-FB0B-4B6C-B731-75A26EEC2BB5}" dt="2022-12-15T09:23:52.649" v="431" actId="164"/>
          <ac:picMkLst>
            <pc:docMk/>
            <pc:sldMk cId="677841024" sldId="256"/>
            <ac:picMk id="9" creationId="{76306DE7-5882-AC2B-976A-B7D393E9E681}"/>
          </ac:picMkLst>
        </pc:picChg>
        <pc:picChg chg="mod topLvl modCrop">
          <ac:chgData name="Nadege Bidan" userId="101290c6-d7fd-4e4f-abb4-82cb3a45689d" providerId="ADAL" clId="{70D8F673-FB0B-4B6C-B731-75A26EEC2BB5}" dt="2022-12-15T09:23:52.649" v="431" actId="164"/>
          <ac:picMkLst>
            <pc:docMk/>
            <pc:sldMk cId="677841024" sldId="256"/>
            <ac:picMk id="10" creationId="{44AC2877-E647-90EF-56BA-B68583B454E3}"/>
          </ac:picMkLst>
        </pc:picChg>
        <pc:picChg chg="mod topLvl modCrop">
          <ac:chgData name="Nadege Bidan" userId="101290c6-d7fd-4e4f-abb4-82cb3a45689d" providerId="ADAL" clId="{70D8F673-FB0B-4B6C-B731-75A26EEC2BB5}" dt="2022-12-15T09:23:52.649" v="431" actId="164"/>
          <ac:picMkLst>
            <pc:docMk/>
            <pc:sldMk cId="677841024" sldId="256"/>
            <ac:picMk id="11" creationId="{737D5D64-123D-D466-0151-09CF9CB712CC}"/>
          </ac:picMkLst>
        </pc:picChg>
        <pc:picChg chg="mod topLvl modCrop">
          <ac:chgData name="Nadege Bidan" userId="101290c6-d7fd-4e4f-abb4-82cb3a45689d" providerId="ADAL" clId="{70D8F673-FB0B-4B6C-B731-75A26EEC2BB5}" dt="2022-12-15T09:23:52.649" v="431" actId="164"/>
          <ac:picMkLst>
            <pc:docMk/>
            <pc:sldMk cId="677841024" sldId="256"/>
            <ac:picMk id="18" creationId="{F0BA575E-802C-5C33-BFD5-A641C6EF8FF4}"/>
          </ac:picMkLst>
        </pc:picChg>
        <pc:picChg chg="mod topLvl modCrop">
          <ac:chgData name="Nadege Bidan" userId="101290c6-d7fd-4e4f-abb4-82cb3a45689d" providerId="ADAL" clId="{70D8F673-FB0B-4B6C-B731-75A26EEC2BB5}" dt="2022-12-15T09:23:52.649" v="431" actId="164"/>
          <ac:picMkLst>
            <pc:docMk/>
            <pc:sldMk cId="677841024" sldId="256"/>
            <ac:picMk id="19" creationId="{B6D771F8-A512-9549-2090-D6B328BD6CFD}"/>
          </ac:picMkLst>
        </pc:picChg>
        <pc:picChg chg="mod topLvl modCrop">
          <ac:chgData name="Nadege Bidan" userId="101290c6-d7fd-4e4f-abb4-82cb3a45689d" providerId="ADAL" clId="{70D8F673-FB0B-4B6C-B731-75A26EEC2BB5}" dt="2022-12-15T09:23:52.649" v="431" actId="164"/>
          <ac:picMkLst>
            <pc:docMk/>
            <pc:sldMk cId="677841024" sldId="256"/>
            <ac:picMk id="20" creationId="{33D1450B-BE1A-B279-F754-8CD8E03FAEE8}"/>
          </ac:picMkLst>
        </pc:picChg>
        <pc:picChg chg="mod topLvl modCrop">
          <ac:chgData name="Nadege Bidan" userId="101290c6-d7fd-4e4f-abb4-82cb3a45689d" providerId="ADAL" clId="{70D8F673-FB0B-4B6C-B731-75A26EEC2BB5}" dt="2022-12-15T09:23:52.649" v="431" actId="164"/>
          <ac:picMkLst>
            <pc:docMk/>
            <pc:sldMk cId="677841024" sldId="256"/>
            <ac:picMk id="21" creationId="{A14575EE-6C88-3CE2-19DA-65C8821F79FB}"/>
          </ac:picMkLst>
        </pc:picChg>
        <pc:picChg chg="mod topLvl modCrop">
          <ac:chgData name="Nadege Bidan" userId="101290c6-d7fd-4e4f-abb4-82cb3a45689d" providerId="ADAL" clId="{70D8F673-FB0B-4B6C-B731-75A26EEC2BB5}" dt="2022-12-15T09:23:52.649" v="431" actId="164"/>
          <ac:picMkLst>
            <pc:docMk/>
            <pc:sldMk cId="677841024" sldId="256"/>
            <ac:picMk id="28" creationId="{DCF3580B-A49D-91BF-13C4-E3DA6726CA27}"/>
          </ac:picMkLst>
        </pc:picChg>
        <pc:picChg chg="mod">
          <ac:chgData name="Nadege Bidan" userId="101290c6-d7fd-4e4f-abb4-82cb3a45689d" providerId="ADAL" clId="{70D8F673-FB0B-4B6C-B731-75A26EEC2BB5}" dt="2022-12-15T08:57:17.736" v="34"/>
          <ac:picMkLst>
            <pc:docMk/>
            <pc:sldMk cId="677841024" sldId="256"/>
            <ac:picMk id="30" creationId="{D6D3BF2A-AD06-07E2-F758-5E6401D3FF94}"/>
          </ac:picMkLst>
        </pc:picChg>
        <pc:picChg chg="mod">
          <ac:chgData name="Nadege Bidan" userId="101290c6-d7fd-4e4f-abb4-82cb3a45689d" providerId="ADAL" clId="{70D8F673-FB0B-4B6C-B731-75A26EEC2BB5}" dt="2022-12-15T08:57:17.736" v="34"/>
          <ac:picMkLst>
            <pc:docMk/>
            <pc:sldMk cId="677841024" sldId="256"/>
            <ac:picMk id="31" creationId="{2AD831A0-554B-1488-50AB-47DB1289E580}"/>
          </ac:picMkLst>
        </pc:picChg>
        <pc:picChg chg="mod">
          <ac:chgData name="Nadege Bidan" userId="101290c6-d7fd-4e4f-abb4-82cb3a45689d" providerId="ADAL" clId="{70D8F673-FB0B-4B6C-B731-75A26EEC2BB5}" dt="2022-12-15T08:57:17.736" v="34"/>
          <ac:picMkLst>
            <pc:docMk/>
            <pc:sldMk cId="677841024" sldId="256"/>
            <ac:picMk id="32" creationId="{B7B5DA0F-BF37-D806-52A4-EC29BD311CDF}"/>
          </ac:picMkLst>
        </pc:picChg>
        <pc:picChg chg="mod">
          <ac:chgData name="Nadege Bidan" userId="101290c6-d7fd-4e4f-abb4-82cb3a45689d" providerId="ADAL" clId="{70D8F673-FB0B-4B6C-B731-75A26EEC2BB5}" dt="2022-12-15T08:57:17.736" v="34"/>
          <ac:picMkLst>
            <pc:docMk/>
            <pc:sldMk cId="677841024" sldId="256"/>
            <ac:picMk id="33" creationId="{E96D2CAF-EDAD-CBF4-4A4B-7E08A5D2E526}"/>
          </ac:picMkLst>
        </pc:picChg>
        <pc:picChg chg="mod">
          <ac:chgData name="Nadege Bidan" userId="101290c6-d7fd-4e4f-abb4-82cb3a45689d" providerId="ADAL" clId="{70D8F673-FB0B-4B6C-B731-75A26EEC2BB5}" dt="2022-12-15T08:57:17.736" v="34"/>
          <ac:picMkLst>
            <pc:docMk/>
            <pc:sldMk cId="677841024" sldId="256"/>
            <ac:picMk id="34" creationId="{FEE95864-AC26-FA92-E58B-6AFD4F0C034C}"/>
          </ac:picMkLst>
        </pc:picChg>
        <pc:picChg chg="mod">
          <ac:chgData name="Nadege Bidan" userId="101290c6-d7fd-4e4f-abb4-82cb3a45689d" providerId="ADAL" clId="{70D8F673-FB0B-4B6C-B731-75A26EEC2BB5}" dt="2022-12-15T08:57:17.736" v="34"/>
          <ac:picMkLst>
            <pc:docMk/>
            <pc:sldMk cId="677841024" sldId="256"/>
            <ac:picMk id="41" creationId="{08C23AB5-1188-3B39-B062-F05CC70B3441}"/>
          </ac:picMkLst>
        </pc:picChg>
        <pc:picChg chg="mod">
          <ac:chgData name="Nadege Bidan" userId="101290c6-d7fd-4e4f-abb4-82cb3a45689d" providerId="ADAL" clId="{70D8F673-FB0B-4B6C-B731-75A26EEC2BB5}" dt="2022-12-15T08:57:17.736" v="34"/>
          <ac:picMkLst>
            <pc:docMk/>
            <pc:sldMk cId="677841024" sldId="256"/>
            <ac:picMk id="42" creationId="{DE3D6D14-416C-D147-8FA5-75DCA7A015A0}"/>
          </ac:picMkLst>
        </pc:picChg>
        <pc:picChg chg="mod">
          <ac:chgData name="Nadege Bidan" userId="101290c6-d7fd-4e4f-abb4-82cb3a45689d" providerId="ADAL" clId="{70D8F673-FB0B-4B6C-B731-75A26EEC2BB5}" dt="2022-12-15T08:57:17.736" v="34"/>
          <ac:picMkLst>
            <pc:docMk/>
            <pc:sldMk cId="677841024" sldId="256"/>
            <ac:picMk id="43" creationId="{745B4B6B-E06C-2B6D-A504-4E52F161B50E}"/>
          </ac:picMkLst>
        </pc:picChg>
        <pc:picChg chg="mod">
          <ac:chgData name="Nadege Bidan" userId="101290c6-d7fd-4e4f-abb4-82cb3a45689d" providerId="ADAL" clId="{70D8F673-FB0B-4B6C-B731-75A26EEC2BB5}" dt="2022-12-15T08:57:17.736" v="34"/>
          <ac:picMkLst>
            <pc:docMk/>
            <pc:sldMk cId="677841024" sldId="256"/>
            <ac:picMk id="44" creationId="{3FB439B5-05D8-BB33-56DD-C68828831C63}"/>
          </ac:picMkLst>
        </pc:picChg>
        <pc:picChg chg="mod">
          <ac:chgData name="Nadege Bidan" userId="101290c6-d7fd-4e4f-abb4-82cb3a45689d" providerId="ADAL" clId="{70D8F673-FB0B-4B6C-B731-75A26EEC2BB5}" dt="2022-12-15T08:57:17.736" v="34"/>
          <ac:picMkLst>
            <pc:docMk/>
            <pc:sldMk cId="677841024" sldId="256"/>
            <ac:picMk id="51" creationId="{6D65808E-7825-14AE-67A5-CA57396F4331}"/>
          </ac:picMkLst>
        </pc:picChg>
        <pc:picChg chg="add mod modCrop">
          <ac:chgData name="Nadege Bidan" userId="101290c6-d7fd-4e4f-abb4-82cb3a45689d" providerId="ADAL" clId="{70D8F673-FB0B-4B6C-B731-75A26EEC2BB5}" dt="2022-12-15T09:23:52.649" v="431" actId="164"/>
          <ac:picMkLst>
            <pc:docMk/>
            <pc:sldMk cId="677841024" sldId="256"/>
            <ac:picMk id="52" creationId="{584D07CA-67B3-6818-440D-E4B7CA5CF74D}"/>
          </ac:picMkLst>
        </pc:picChg>
        <pc:picChg chg="add mod">
          <ac:chgData name="Nadege Bidan" userId="101290c6-d7fd-4e4f-abb4-82cb3a45689d" providerId="ADAL" clId="{70D8F673-FB0B-4B6C-B731-75A26EEC2BB5}" dt="2022-12-21T16:10:17.415" v="1239" actId="164"/>
          <ac:picMkLst>
            <pc:docMk/>
            <pc:sldMk cId="677841024" sldId="256"/>
            <ac:picMk id="91" creationId="{DC126256-9247-0157-BD33-136582D0884B}"/>
          </ac:picMkLst>
        </pc:picChg>
        <pc:picChg chg="add mod">
          <ac:chgData name="Nadege Bidan" userId="101290c6-d7fd-4e4f-abb4-82cb3a45689d" providerId="ADAL" clId="{70D8F673-FB0B-4B6C-B731-75A26EEC2BB5}" dt="2022-12-21T16:10:17.415" v="1239" actId="164"/>
          <ac:picMkLst>
            <pc:docMk/>
            <pc:sldMk cId="677841024" sldId="256"/>
            <ac:picMk id="92" creationId="{483DEF6D-A59A-EC61-B245-9AA638985718}"/>
          </ac:picMkLst>
        </pc:picChg>
        <pc:picChg chg="add mod">
          <ac:chgData name="Nadege Bidan" userId="101290c6-d7fd-4e4f-abb4-82cb3a45689d" providerId="ADAL" clId="{70D8F673-FB0B-4B6C-B731-75A26EEC2BB5}" dt="2022-12-21T16:10:17.415" v="1239" actId="164"/>
          <ac:picMkLst>
            <pc:docMk/>
            <pc:sldMk cId="677841024" sldId="256"/>
            <ac:picMk id="93" creationId="{0BF725DF-29A7-CF8C-45C3-B0A82248ECDD}"/>
          </ac:picMkLst>
        </pc:picChg>
        <pc:picChg chg="add mod">
          <ac:chgData name="Nadege Bidan" userId="101290c6-d7fd-4e4f-abb4-82cb3a45689d" providerId="ADAL" clId="{70D8F673-FB0B-4B6C-B731-75A26EEC2BB5}" dt="2022-12-21T16:10:04.150" v="1237" actId="164"/>
          <ac:picMkLst>
            <pc:docMk/>
            <pc:sldMk cId="677841024" sldId="256"/>
            <ac:picMk id="95" creationId="{B1019843-FB68-D1E7-3E9D-2D38FC455968}"/>
          </ac:picMkLst>
        </pc:picChg>
        <pc:picChg chg="add mod">
          <ac:chgData name="Nadege Bidan" userId="101290c6-d7fd-4e4f-abb4-82cb3a45689d" providerId="ADAL" clId="{70D8F673-FB0B-4B6C-B731-75A26EEC2BB5}" dt="2022-12-21T16:08:26.832" v="1160" actId="164"/>
          <ac:picMkLst>
            <pc:docMk/>
            <pc:sldMk cId="677841024" sldId="256"/>
            <ac:picMk id="96" creationId="{078CDA1E-8441-231F-C0D4-9109AC3E931B}"/>
          </ac:picMkLst>
        </pc:picChg>
        <pc:picChg chg="add mod">
          <ac:chgData name="Nadege Bidan" userId="101290c6-d7fd-4e4f-abb4-82cb3a45689d" providerId="ADAL" clId="{70D8F673-FB0B-4B6C-B731-75A26EEC2BB5}" dt="2022-12-21T16:08:26.832" v="1160" actId="164"/>
          <ac:picMkLst>
            <pc:docMk/>
            <pc:sldMk cId="677841024" sldId="256"/>
            <ac:picMk id="97" creationId="{AF23388F-220B-1BC9-59B2-96C463445ADA}"/>
          </ac:picMkLst>
        </pc:picChg>
        <pc:picChg chg="add mod">
          <ac:chgData name="Nadege Bidan" userId="101290c6-d7fd-4e4f-abb4-82cb3a45689d" providerId="ADAL" clId="{70D8F673-FB0B-4B6C-B731-75A26EEC2BB5}" dt="2022-12-21T16:08:26.832" v="1160" actId="164"/>
          <ac:picMkLst>
            <pc:docMk/>
            <pc:sldMk cId="677841024" sldId="256"/>
            <ac:picMk id="98" creationId="{26F9EF65-ADA1-E4D0-2600-BFFDFB511333}"/>
          </ac:picMkLst>
        </pc:picChg>
        <pc:picChg chg="add mod">
          <ac:chgData name="Nadege Bidan" userId="101290c6-d7fd-4e4f-abb4-82cb3a45689d" providerId="ADAL" clId="{70D8F673-FB0B-4B6C-B731-75A26EEC2BB5}" dt="2022-12-21T16:10:04.150" v="1237" actId="164"/>
          <ac:picMkLst>
            <pc:docMk/>
            <pc:sldMk cId="677841024" sldId="256"/>
            <ac:picMk id="99" creationId="{FAE4639C-F442-1903-8E8E-C0C2EAF8A641}"/>
          </ac:picMkLst>
        </pc:picChg>
        <pc:picChg chg="add mod">
          <ac:chgData name="Nadege Bidan" userId="101290c6-d7fd-4e4f-abb4-82cb3a45689d" providerId="ADAL" clId="{70D8F673-FB0B-4B6C-B731-75A26EEC2BB5}" dt="2022-12-21T16:10:04.150" v="1237" actId="164"/>
          <ac:picMkLst>
            <pc:docMk/>
            <pc:sldMk cId="677841024" sldId="256"/>
            <ac:picMk id="100" creationId="{CA95F4E7-04FF-581F-9960-E8949ADCB36E}"/>
          </ac:picMkLst>
        </pc:picChg>
      </pc:sldChg>
      <pc:sldChg chg="addSp delSp modSp del mod">
        <pc:chgData name="Nadege Bidan" userId="101290c6-d7fd-4e4f-abb4-82cb3a45689d" providerId="ADAL" clId="{70D8F673-FB0B-4B6C-B731-75A26EEC2BB5}" dt="2022-12-15T09:24:12.559" v="432" actId="47"/>
        <pc:sldMkLst>
          <pc:docMk/>
          <pc:sldMk cId="3159273194" sldId="258"/>
        </pc:sldMkLst>
        <pc:grpChg chg="mod">
          <ac:chgData name="Nadege Bidan" userId="101290c6-d7fd-4e4f-abb4-82cb3a45689d" providerId="ADAL" clId="{70D8F673-FB0B-4B6C-B731-75A26EEC2BB5}" dt="2022-12-15T08:54:48.510" v="14" actId="1076"/>
          <ac:grpSpMkLst>
            <pc:docMk/>
            <pc:sldMk cId="3159273194" sldId="258"/>
            <ac:grpSpMk id="6" creationId="{347A7C75-11B3-73FE-03FC-CAD3CF5EB616}"/>
          </ac:grpSpMkLst>
        </pc:grpChg>
        <pc:picChg chg="add del mod">
          <ac:chgData name="Nadege Bidan" userId="101290c6-d7fd-4e4f-abb4-82cb3a45689d" providerId="ADAL" clId="{70D8F673-FB0B-4B6C-B731-75A26EEC2BB5}" dt="2022-12-15T08:56:47.604" v="28" actId="478"/>
          <ac:picMkLst>
            <pc:docMk/>
            <pc:sldMk cId="3159273194" sldId="258"/>
            <ac:picMk id="4" creationId="{948E34B9-081D-4588-94AD-5AF9C02576AF}"/>
          </ac:picMkLst>
        </pc:picChg>
        <pc:picChg chg="mod modCrop">
          <ac:chgData name="Nadege Bidan" userId="101290c6-d7fd-4e4f-abb4-82cb3a45689d" providerId="ADAL" clId="{70D8F673-FB0B-4B6C-B731-75A26EEC2BB5}" dt="2022-12-15T08:55:44.718" v="19" actId="732"/>
          <ac:picMkLst>
            <pc:docMk/>
            <pc:sldMk cId="3159273194" sldId="258"/>
            <ac:picMk id="13" creationId="{ECD6C353-C137-36E4-336E-94A5754924B4}"/>
          </ac:picMkLst>
        </pc:picChg>
      </pc:sldChg>
    </pc:docChg>
  </pc:docChgLst>
  <pc:docChgLst>
    <pc:chgData name="Claire Beraud" userId="S::claire.beraud@urosphere.com::88d8f020-165f-4369-a606-bc2a6e18c31d" providerId="AD" clId="Web-{A1033BD0-38B2-4002-BC5C-0E4F7154A8EF}"/>
    <pc:docChg chg="modSld">
      <pc:chgData name="Claire Beraud" userId="S::claire.beraud@urosphere.com::88d8f020-165f-4369-a606-bc2a6e18c31d" providerId="AD" clId="Web-{A1033BD0-38B2-4002-BC5C-0E4F7154A8EF}" dt="2022-12-19T08:39:26.639" v="0"/>
      <pc:docMkLst>
        <pc:docMk/>
      </pc:docMkLst>
      <pc:sldChg chg="delSp">
        <pc:chgData name="Claire Beraud" userId="S::claire.beraud@urosphere.com::88d8f020-165f-4369-a606-bc2a6e18c31d" providerId="AD" clId="Web-{A1033BD0-38B2-4002-BC5C-0E4F7154A8EF}" dt="2022-12-19T08:39:26.639" v="0"/>
        <pc:sldMkLst>
          <pc:docMk/>
          <pc:sldMk cId="677841024" sldId="256"/>
        </pc:sldMkLst>
        <pc:spChg chg="del">
          <ac:chgData name="Claire Beraud" userId="S::claire.beraud@urosphere.com::88d8f020-165f-4369-a606-bc2a6e18c31d" providerId="AD" clId="Web-{A1033BD0-38B2-4002-BC5C-0E4F7154A8EF}" dt="2022-12-19T08:39:26.639" v="0"/>
          <ac:spMkLst>
            <pc:docMk/>
            <pc:sldMk cId="677841024" sldId="256"/>
            <ac:spMk id="2" creationId="{8FBD1D0F-68C2-AC70-EF99-EF56D33A2BC3}"/>
          </ac:spMkLst>
        </pc:spChg>
      </pc:sldChg>
    </pc:docChg>
  </pc:docChgLst>
  <pc:docChgLst>
    <pc:chgData name="Claire Beraud" userId="S::claire.beraud@urosphere.com::88d8f020-165f-4369-a606-bc2a6e18c31d" providerId="AD" clId="Web-{81098340-4A07-4817-B779-AF776C6D6F72}"/>
    <pc:docChg chg="modSld">
      <pc:chgData name="Claire Beraud" userId="S::claire.beraud@urosphere.com::88d8f020-165f-4369-a606-bc2a6e18c31d" providerId="AD" clId="Web-{81098340-4A07-4817-B779-AF776C6D6F72}" dt="2022-11-11T13:31:07.447" v="1" actId="20577"/>
      <pc:docMkLst>
        <pc:docMk/>
      </pc:docMkLst>
      <pc:sldChg chg="modSp">
        <pc:chgData name="Claire Beraud" userId="S::claire.beraud@urosphere.com::88d8f020-165f-4369-a606-bc2a6e18c31d" providerId="AD" clId="Web-{81098340-4A07-4817-B779-AF776C6D6F72}" dt="2022-11-11T13:31:07.447" v="1" actId="20577"/>
        <pc:sldMkLst>
          <pc:docMk/>
          <pc:sldMk cId="677841024" sldId="256"/>
        </pc:sldMkLst>
        <pc:spChg chg="mod">
          <ac:chgData name="Claire Beraud" userId="S::claire.beraud@urosphere.com::88d8f020-165f-4369-a606-bc2a6e18c31d" providerId="AD" clId="Web-{81098340-4A07-4817-B779-AF776C6D6F72}" dt="2022-11-11T13:31:07.447" v="1" actId="20577"/>
          <ac:spMkLst>
            <pc:docMk/>
            <pc:sldMk cId="677841024" sldId="256"/>
            <ac:spMk id="2" creationId="{8FBD1D0F-68C2-AC70-EF99-EF56D33A2BC3}"/>
          </ac:spMkLst>
        </pc:spChg>
      </pc:sldChg>
    </pc:docChg>
  </pc:docChgLst>
  <pc:docChgLst>
    <pc:chgData name="Claire Beraud" userId="S::claire.beraud@urosphere.com::88d8f020-165f-4369-a606-bc2a6e18c31d" providerId="AD" clId="Web-{9A1B9678-A187-47F6-8D29-DBE71C61F900}"/>
    <pc:docChg chg="modSld">
      <pc:chgData name="Claire Beraud" userId="S::claire.beraud@urosphere.com::88d8f020-165f-4369-a606-bc2a6e18c31d" providerId="AD" clId="Web-{9A1B9678-A187-47F6-8D29-DBE71C61F900}" dt="2022-12-12T14:36:46.059" v="0" actId="20577"/>
      <pc:docMkLst>
        <pc:docMk/>
      </pc:docMkLst>
      <pc:sldChg chg="modSp">
        <pc:chgData name="Claire Beraud" userId="S::claire.beraud@urosphere.com::88d8f020-165f-4369-a606-bc2a6e18c31d" providerId="AD" clId="Web-{9A1B9678-A187-47F6-8D29-DBE71C61F900}" dt="2022-12-12T14:36:46.059" v="0" actId="20577"/>
        <pc:sldMkLst>
          <pc:docMk/>
          <pc:sldMk cId="677841024" sldId="256"/>
        </pc:sldMkLst>
        <pc:spChg chg="mod">
          <ac:chgData name="Claire Beraud" userId="S::claire.beraud@urosphere.com::88d8f020-165f-4369-a606-bc2a6e18c31d" providerId="AD" clId="Web-{9A1B9678-A187-47F6-8D29-DBE71C61F900}" dt="2022-12-12T14:36:46.059" v="0" actId="20577"/>
          <ac:spMkLst>
            <pc:docMk/>
            <pc:sldMk cId="677841024" sldId="256"/>
            <ac:spMk id="2" creationId="{8FBD1D0F-68C2-AC70-EF99-EF56D33A2BC3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25561" y="4729513"/>
            <a:ext cx="18423017" cy="10061081"/>
          </a:xfrm>
        </p:spPr>
        <p:txBody>
          <a:bodyPr anchor="b"/>
          <a:lstStyle>
            <a:lvl1pPr algn="ctr">
              <a:defRPr sz="14222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709267" y="15178588"/>
            <a:ext cx="16255604" cy="6977197"/>
          </a:xfrm>
        </p:spPr>
        <p:txBody>
          <a:bodyPr/>
          <a:lstStyle>
            <a:lvl1pPr marL="0" indent="0" algn="ctr">
              <a:buNone/>
              <a:defRPr sz="5689"/>
            </a:lvl1pPr>
            <a:lvl2pPr marL="1083701" indent="0" algn="ctr">
              <a:buNone/>
              <a:defRPr sz="4741"/>
            </a:lvl2pPr>
            <a:lvl3pPr marL="2167402" indent="0" algn="ctr">
              <a:buNone/>
              <a:defRPr sz="4267"/>
            </a:lvl3pPr>
            <a:lvl4pPr marL="3251103" indent="0" algn="ctr">
              <a:buNone/>
              <a:defRPr sz="3792"/>
            </a:lvl4pPr>
            <a:lvl5pPr marL="4334805" indent="0" algn="ctr">
              <a:buNone/>
              <a:defRPr sz="3792"/>
            </a:lvl5pPr>
            <a:lvl6pPr marL="5418506" indent="0" algn="ctr">
              <a:buNone/>
              <a:defRPr sz="3792"/>
            </a:lvl6pPr>
            <a:lvl7pPr marL="6502207" indent="0" algn="ctr">
              <a:buNone/>
              <a:defRPr sz="3792"/>
            </a:lvl7pPr>
            <a:lvl8pPr marL="7585908" indent="0" algn="ctr">
              <a:buNone/>
              <a:defRPr sz="3792"/>
            </a:lvl8pPr>
            <a:lvl9pPr marL="8669609" indent="0" algn="ctr">
              <a:buNone/>
              <a:defRPr sz="3792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AC7F-EF4C-4155-A858-571C9900A6CA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8B2DA-9557-455E-AB28-00560F289F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97316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AC7F-EF4C-4155-A858-571C9900A6CA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8B2DA-9557-455E-AB28-00560F289F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41891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510556" y="1538596"/>
            <a:ext cx="4673486" cy="2449044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90098" y="1538596"/>
            <a:ext cx="13749531" cy="2449044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AC7F-EF4C-4155-A858-571C9900A6CA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8B2DA-9557-455E-AB28-00560F289F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394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AC7F-EF4C-4155-A858-571C9900A6CA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8B2DA-9557-455E-AB28-00560F289F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3839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78810" y="7204652"/>
            <a:ext cx="18693944" cy="12021117"/>
          </a:xfrm>
        </p:spPr>
        <p:txBody>
          <a:bodyPr anchor="b"/>
          <a:lstStyle>
            <a:lvl1pPr>
              <a:defRPr sz="14222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78810" y="19339494"/>
            <a:ext cx="18693944" cy="6321621"/>
          </a:xfrm>
        </p:spPr>
        <p:txBody>
          <a:bodyPr/>
          <a:lstStyle>
            <a:lvl1pPr marL="0" indent="0">
              <a:buNone/>
              <a:defRPr sz="5689">
                <a:solidFill>
                  <a:schemeClr val="tx1"/>
                </a:solidFill>
              </a:defRPr>
            </a:lvl1pPr>
            <a:lvl2pPr marL="1083701" indent="0">
              <a:buNone/>
              <a:defRPr sz="4741">
                <a:solidFill>
                  <a:schemeClr val="tx1">
                    <a:tint val="75000"/>
                  </a:schemeClr>
                </a:solidFill>
              </a:defRPr>
            </a:lvl2pPr>
            <a:lvl3pPr marL="2167402" indent="0">
              <a:buNone/>
              <a:defRPr sz="4267">
                <a:solidFill>
                  <a:schemeClr val="tx1">
                    <a:tint val="75000"/>
                  </a:schemeClr>
                </a:solidFill>
              </a:defRPr>
            </a:lvl3pPr>
            <a:lvl4pPr marL="3251103" indent="0">
              <a:buNone/>
              <a:defRPr sz="3792">
                <a:solidFill>
                  <a:schemeClr val="tx1">
                    <a:tint val="75000"/>
                  </a:schemeClr>
                </a:solidFill>
              </a:defRPr>
            </a:lvl4pPr>
            <a:lvl5pPr marL="4334805" indent="0">
              <a:buNone/>
              <a:defRPr sz="3792">
                <a:solidFill>
                  <a:schemeClr val="tx1">
                    <a:tint val="75000"/>
                  </a:schemeClr>
                </a:solidFill>
              </a:defRPr>
            </a:lvl5pPr>
            <a:lvl6pPr marL="5418506" indent="0">
              <a:buNone/>
              <a:defRPr sz="3792">
                <a:solidFill>
                  <a:schemeClr val="tx1">
                    <a:tint val="75000"/>
                  </a:schemeClr>
                </a:solidFill>
              </a:defRPr>
            </a:lvl6pPr>
            <a:lvl7pPr marL="6502207" indent="0">
              <a:buNone/>
              <a:defRPr sz="3792">
                <a:solidFill>
                  <a:schemeClr val="tx1">
                    <a:tint val="75000"/>
                  </a:schemeClr>
                </a:solidFill>
              </a:defRPr>
            </a:lvl7pPr>
            <a:lvl8pPr marL="7585908" indent="0">
              <a:buNone/>
              <a:defRPr sz="3792">
                <a:solidFill>
                  <a:schemeClr val="tx1">
                    <a:tint val="75000"/>
                  </a:schemeClr>
                </a:solidFill>
              </a:defRPr>
            </a:lvl8pPr>
            <a:lvl9pPr marL="8669609" indent="0">
              <a:buNone/>
              <a:defRPr sz="379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AC7F-EF4C-4155-A858-571C9900A6CA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8B2DA-9557-455E-AB28-00560F289F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03362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90097" y="7692981"/>
            <a:ext cx="9211509" cy="183360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72532" y="7692981"/>
            <a:ext cx="9211509" cy="183360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AC7F-EF4C-4155-A858-571C9900A6CA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8B2DA-9557-455E-AB28-00560F289F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3376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92920" y="1538603"/>
            <a:ext cx="18693944" cy="558577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92922" y="7084234"/>
            <a:ext cx="9169175" cy="3471874"/>
          </a:xfrm>
        </p:spPr>
        <p:txBody>
          <a:bodyPr anchor="b"/>
          <a:lstStyle>
            <a:lvl1pPr marL="0" indent="0">
              <a:buNone/>
              <a:defRPr sz="5689" b="1"/>
            </a:lvl1pPr>
            <a:lvl2pPr marL="1083701" indent="0">
              <a:buNone/>
              <a:defRPr sz="4741" b="1"/>
            </a:lvl2pPr>
            <a:lvl3pPr marL="2167402" indent="0">
              <a:buNone/>
              <a:defRPr sz="4267" b="1"/>
            </a:lvl3pPr>
            <a:lvl4pPr marL="3251103" indent="0">
              <a:buNone/>
              <a:defRPr sz="3792" b="1"/>
            </a:lvl4pPr>
            <a:lvl5pPr marL="4334805" indent="0">
              <a:buNone/>
              <a:defRPr sz="3792" b="1"/>
            </a:lvl5pPr>
            <a:lvl6pPr marL="5418506" indent="0">
              <a:buNone/>
              <a:defRPr sz="3792" b="1"/>
            </a:lvl6pPr>
            <a:lvl7pPr marL="6502207" indent="0">
              <a:buNone/>
              <a:defRPr sz="3792" b="1"/>
            </a:lvl7pPr>
            <a:lvl8pPr marL="7585908" indent="0">
              <a:buNone/>
              <a:defRPr sz="3792" b="1"/>
            </a:lvl8pPr>
            <a:lvl9pPr marL="8669609" indent="0">
              <a:buNone/>
              <a:defRPr sz="379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92922" y="10556108"/>
            <a:ext cx="9169175" cy="155264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972533" y="7084234"/>
            <a:ext cx="9214332" cy="3471874"/>
          </a:xfrm>
        </p:spPr>
        <p:txBody>
          <a:bodyPr anchor="b"/>
          <a:lstStyle>
            <a:lvl1pPr marL="0" indent="0">
              <a:buNone/>
              <a:defRPr sz="5689" b="1"/>
            </a:lvl1pPr>
            <a:lvl2pPr marL="1083701" indent="0">
              <a:buNone/>
              <a:defRPr sz="4741" b="1"/>
            </a:lvl2pPr>
            <a:lvl3pPr marL="2167402" indent="0">
              <a:buNone/>
              <a:defRPr sz="4267" b="1"/>
            </a:lvl3pPr>
            <a:lvl4pPr marL="3251103" indent="0">
              <a:buNone/>
              <a:defRPr sz="3792" b="1"/>
            </a:lvl4pPr>
            <a:lvl5pPr marL="4334805" indent="0">
              <a:buNone/>
              <a:defRPr sz="3792" b="1"/>
            </a:lvl5pPr>
            <a:lvl6pPr marL="5418506" indent="0">
              <a:buNone/>
              <a:defRPr sz="3792" b="1"/>
            </a:lvl6pPr>
            <a:lvl7pPr marL="6502207" indent="0">
              <a:buNone/>
              <a:defRPr sz="3792" b="1"/>
            </a:lvl7pPr>
            <a:lvl8pPr marL="7585908" indent="0">
              <a:buNone/>
              <a:defRPr sz="3792" b="1"/>
            </a:lvl8pPr>
            <a:lvl9pPr marL="8669609" indent="0">
              <a:buNone/>
              <a:defRPr sz="379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972533" y="10556108"/>
            <a:ext cx="9214332" cy="155264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AC7F-EF4C-4155-A858-571C9900A6CA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8B2DA-9557-455E-AB28-00560F289F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4390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AC7F-EF4C-4155-A858-571C9900A6CA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8B2DA-9557-455E-AB28-00560F289F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6191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AC7F-EF4C-4155-A858-571C9900A6CA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8B2DA-9557-455E-AB28-00560F289F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39286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92920" y="1926590"/>
            <a:ext cx="6990474" cy="6743065"/>
          </a:xfrm>
        </p:spPr>
        <p:txBody>
          <a:bodyPr anchor="b"/>
          <a:lstStyle>
            <a:lvl1pPr>
              <a:defRPr sz="758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214332" y="4160906"/>
            <a:ext cx="10972532" cy="20536914"/>
          </a:xfrm>
        </p:spPr>
        <p:txBody>
          <a:bodyPr/>
          <a:lstStyle>
            <a:lvl1pPr>
              <a:defRPr sz="7585"/>
            </a:lvl1pPr>
            <a:lvl2pPr>
              <a:defRPr sz="6637"/>
            </a:lvl2pPr>
            <a:lvl3pPr>
              <a:defRPr sz="5689"/>
            </a:lvl3pPr>
            <a:lvl4pPr>
              <a:defRPr sz="4741"/>
            </a:lvl4pPr>
            <a:lvl5pPr>
              <a:defRPr sz="4741"/>
            </a:lvl5pPr>
            <a:lvl6pPr>
              <a:defRPr sz="4741"/>
            </a:lvl6pPr>
            <a:lvl7pPr>
              <a:defRPr sz="4741"/>
            </a:lvl7pPr>
            <a:lvl8pPr>
              <a:defRPr sz="4741"/>
            </a:lvl8pPr>
            <a:lvl9pPr>
              <a:defRPr sz="474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92920" y="8669655"/>
            <a:ext cx="6990474" cy="16061608"/>
          </a:xfrm>
        </p:spPr>
        <p:txBody>
          <a:bodyPr/>
          <a:lstStyle>
            <a:lvl1pPr marL="0" indent="0">
              <a:buNone/>
              <a:defRPr sz="3792"/>
            </a:lvl1pPr>
            <a:lvl2pPr marL="1083701" indent="0">
              <a:buNone/>
              <a:defRPr sz="3318"/>
            </a:lvl2pPr>
            <a:lvl3pPr marL="2167402" indent="0">
              <a:buNone/>
              <a:defRPr sz="2844"/>
            </a:lvl3pPr>
            <a:lvl4pPr marL="3251103" indent="0">
              <a:buNone/>
              <a:defRPr sz="2370"/>
            </a:lvl4pPr>
            <a:lvl5pPr marL="4334805" indent="0">
              <a:buNone/>
              <a:defRPr sz="2370"/>
            </a:lvl5pPr>
            <a:lvl6pPr marL="5418506" indent="0">
              <a:buNone/>
              <a:defRPr sz="2370"/>
            </a:lvl6pPr>
            <a:lvl7pPr marL="6502207" indent="0">
              <a:buNone/>
              <a:defRPr sz="2370"/>
            </a:lvl7pPr>
            <a:lvl8pPr marL="7585908" indent="0">
              <a:buNone/>
              <a:defRPr sz="2370"/>
            </a:lvl8pPr>
            <a:lvl9pPr marL="8669609" indent="0">
              <a:buNone/>
              <a:defRPr sz="23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AC7F-EF4C-4155-A858-571C9900A6CA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8B2DA-9557-455E-AB28-00560F289F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4777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92920" y="1926590"/>
            <a:ext cx="6990474" cy="6743065"/>
          </a:xfrm>
        </p:spPr>
        <p:txBody>
          <a:bodyPr anchor="b"/>
          <a:lstStyle>
            <a:lvl1pPr>
              <a:defRPr sz="758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214332" y="4160906"/>
            <a:ext cx="10972532" cy="20536914"/>
          </a:xfrm>
        </p:spPr>
        <p:txBody>
          <a:bodyPr anchor="t"/>
          <a:lstStyle>
            <a:lvl1pPr marL="0" indent="0">
              <a:buNone/>
              <a:defRPr sz="7585"/>
            </a:lvl1pPr>
            <a:lvl2pPr marL="1083701" indent="0">
              <a:buNone/>
              <a:defRPr sz="6637"/>
            </a:lvl2pPr>
            <a:lvl3pPr marL="2167402" indent="0">
              <a:buNone/>
              <a:defRPr sz="5689"/>
            </a:lvl3pPr>
            <a:lvl4pPr marL="3251103" indent="0">
              <a:buNone/>
              <a:defRPr sz="4741"/>
            </a:lvl4pPr>
            <a:lvl5pPr marL="4334805" indent="0">
              <a:buNone/>
              <a:defRPr sz="4741"/>
            </a:lvl5pPr>
            <a:lvl6pPr marL="5418506" indent="0">
              <a:buNone/>
              <a:defRPr sz="4741"/>
            </a:lvl6pPr>
            <a:lvl7pPr marL="6502207" indent="0">
              <a:buNone/>
              <a:defRPr sz="4741"/>
            </a:lvl7pPr>
            <a:lvl8pPr marL="7585908" indent="0">
              <a:buNone/>
              <a:defRPr sz="4741"/>
            </a:lvl8pPr>
            <a:lvl9pPr marL="8669609" indent="0">
              <a:buNone/>
              <a:defRPr sz="4741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92920" y="8669655"/>
            <a:ext cx="6990474" cy="16061608"/>
          </a:xfrm>
        </p:spPr>
        <p:txBody>
          <a:bodyPr/>
          <a:lstStyle>
            <a:lvl1pPr marL="0" indent="0">
              <a:buNone/>
              <a:defRPr sz="3792"/>
            </a:lvl1pPr>
            <a:lvl2pPr marL="1083701" indent="0">
              <a:buNone/>
              <a:defRPr sz="3318"/>
            </a:lvl2pPr>
            <a:lvl3pPr marL="2167402" indent="0">
              <a:buNone/>
              <a:defRPr sz="2844"/>
            </a:lvl3pPr>
            <a:lvl4pPr marL="3251103" indent="0">
              <a:buNone/>
              <a:defRPr sz="2370"/>
            </a:lvl4pPr>
            <a:lvl5pPr marL="4334805" indent="0">
              <a:buNone/>
              <a:defRPr sz="2370"/>
            </a:lvl5pPr>
            <a:lvl6pPr marL="5418506" indent="0">
              <a:buNone/>
              <a:defRPr sz="2370"/>
            </a:lvl6pPr>
            <a:lvl7pPr marL="6502207" indent="0">
              <a:buNone/>
              <a:defRPr sz="2370"/>
            </a:lvl7pPr>
            <a:lvl8pPr marL="7585908" indent="0">
              <a:buNone/>
              <a:defRPr sz="2370"/>
            </a:lvl8pPr>
            <a:lvl9pPr marL="8669609" indent="0">
              <a:buNone/>
              <a:defRPr sz="23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2AC7F-EF4C-4155-A858-571C9900A6CA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8B2DA-9557-455E-AB28-00560F289F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0307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90097" y="1538603"/>
            <a:ext cx="18693944" cy="55857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90097" y="7692981"/>
            <a:ext cx="18693944" cy="183360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90097" y="26784959"/>
            <a:ext cx="4876681" cy="15385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84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B2AC7F-EF4C-4155-A858-571C9900A6CA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179558" y="26784959"/>
            <a:ext cx="7315022" cy="15385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84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5307360" y="26784959"/>
            <a:ext cx="4876681" cy="15385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84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88B2DA-9557-455E-AB28-00560F289F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4980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2167402" rtl="0" eaLnBrk="1" latinLnBrk="0" hangingPunct="1">
        <a:lnSpc>
          <a:spcPct val="90000"/>
        </a:lnSpc>
        <a:spcBef>
          <a:spcPct val="0"/>
        </a:spcBef>
        <a:buNone/>
        <a:defRPr sz="104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41851" indent="-541851" algn="l" defTabSz="2167402" rtl="0" eaLnBrk="1" latinLnBrk="0" hangingPunct="1">
        <a:lnSpc>
          <a:spcPct val="90000"/>
        </a:lnSpc>
        <a:spcBef>
          <a:spcPts val="2370"/>
        </a:spcBef>
        <a:buFont typeface="Arial" panose="020B0604020202020204" pitchFamily="34" charset="0"/>
        <a:buChar char="•"/>
        <a:defRPr sz="6637" kern="1200">
          <a:solidFill>
            <a:schemeClr val="tx1"/>
          </a:solidFill>
          <a:latin typeface="+mn-lt"/>
          <a:ea typeface="+mn-ea"/>
          <a:cs typeface="+mn-cs"/>
        </a:defRPr>
      </a:lvl1pPr>
      <a:lvl2pPr marL="1625552" indent="-541851" algn="l" defTabSz="2167402" rtl="0" eaLnBrk="1" latinLnBrk="0" hangingPunct="1">
        <a:lnSpc>
          <a:spcPct val="90000"/>
        </a:lnSpc>
        <a:spcBef>
          <a:spcPts val="1185"/>
        </a:spcBef>
        <a:buFont typeface="Arial" panose="020B0604020202020204" pitchFamily="34" charset="0"/>
        <a:buChar char="•"/>
        <a:defRPr sz="5689" kern="1200">
          <a:solidFill>
            <a:schemeClr val="tx1"/>
          </a:solidFill>
          <a:latin typeface="+mn-lt"/>
          <a:ea typeface="+mn-ea"/>
          <a:cs typeface="+mn-cs"/>
        </a:defRPr>
      </a:lvl2pPr>
      <a:lvl3pPr marL="2709253" indent="-541851" algn="l" defTabSz="2167402" rtl="0" eaLnBrk="1" latinLnBrk="0" hangingPunct="1">
        <a:lnSpc>
          <a:spcPct val="90000"/>
        </a:lnSpc>
        <a:spcBef>
          <a:spcPts val="1185"/>
        </a:spcBef>
        <a:buFont typeface="Arial" panose="020B0604020202020204" pitchFamily="34" charset="0"/>
        <a:buChar char="•"/>
        <a:defRPr sz="4741" kern="1200">
          <a:solidFill>
            <a:schemeClr val="tx1"/>
          </a:solidFill>
          <a:latin typeface="+mn-lt"/>
          <a:ea typeface="+mn-ea"/>
          <a:cs typeface="+mn-cs"/>
        </a:defRPr>
      </a:lvl3pPr>
      <a:lvl4pPr marL="3792954" indent="-541851" algn="l" defTabSz="2167402" rtl="0" eaLnBrk="1" latinLnBrk="0" hangingPunct="1">
        <a:lnSpc>
          <a:spcPct val="90000"/>
        </a:lnSpc>
        <a:spcBef>
          <a:spcPts val="1185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4pPr>
      <a:lvl5pPr marL="4876655" indent="-541851" algn="l" defTabSz="2167402" rtl="0" eaLnBrk="1" latinLnBrk="0" hangingPunct="1">
        <a:lnSpc>
          <a:spcPct val="90000"/>
        </a:lnSpc>
        <a:spcBef>
          <a:spcPts val="1185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5pPr>
      <a:lvl6pPr marL="5960356" indent="-541851" algn="l" defTabSz="2167402" rtl="0" eaLnBrk="1" latinLnBrk="0" hangingPunct="1">
        <a:lnSpc>
          <a:spcPct val="90000"/>
        </a:lnSpc>
        <a:spcBef>
          <a:spcPts val="1185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6pPr>
      <a:lvl7pPr marL="7044058" indent="-541851" algn="l" defTabSz="2167402" rtl="0" eaLnBrk="1" latinLnBrk="0" hangingPunct="1">
        <a:lnSpc>
          <a:spcPct val="90000"/>
        </a:lnSpc>
        <a:spcBef>
          <a:spcPts val="1185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7pPr>
      <a:lvl8pPr marL="8127759" indent="-541851" algn="l" defTabSz="2167402" rtl="0" eaLnBrk="1" latinLnBrk="0" hangingPunct="1">
        <a:lnSpc>
          <a:spcPct val="90000"/>
        </a:lnSpc>
        <a:spcBef>
          <a:spcPts val="1185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8pPr>
      <a:lvl9pPr marL="9211460" indent="-541851" algn="l" defTabSz="2167402" rtl="0" eaLnBrk="1" latinLnBrk="0" hangingPunct="1">
        <a:lnSpc>
          <a:spcPct val="90000"/>
        </a:lnSpc>
        <a:spcBef>
          <a:spcPts val="1185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167402" rtl="0" eaLnBrk="1" latinLnBrk="0" hangingPunct="1">
        <a:defRPr sz="4267" kern="1200">
          <a:solidFill>
            <a:schemeClr val="tx1"/>
          </a:solidFill>
          <a:latin typeface="+mn-lt"/>
          <a:ea typeface="+mn-ea"/>
          <a:cs typeface="+mn-cs"/>
        </a:defRPr>
      </a:lvl1pPr>
      <a:lvl2pPr marL="1083701" algn="l" defTabSz="2167402" rtl="0" eaLnBrk="1" latinLnBrk="0" hangingPunct="1"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167402" algn="l" defTabSz="2167402" rtl="0" eaLnBrk="1" latinLnBrk="0" hangingPunct="1">
        <a:defRPr sz="4267" kern="1200">
          <a:solidFill>
            <a:schemeClr val="tx1"/>
          </a:solidFill>
          <a:latin typeface="+mn-lt"/>
          <a:ea typeface="+mn-ea"/>
          <a:cs typeface="+mn-cs"/>
        </a:defRPr>
      </a:lvl3pPr>
      <a:lvl4pPr marL="3251103" algn="l" defTabSz="2167402" rtl="0" eaLnBrk="1" latinLnBrk="0" hangingPunct="1">
        <a:defRPr sz="4267" kern="1200">
          <a:solidFill>
            <a:schemeClr val="tx1"/>
          </a:solidFill>
          <a:latin typeface="+mn-lt"/>
          <a:ea typeface="+mn-ea"/>
          <a:cs typeface="+mn-cs"/>
        </a:defRPr>
      </a:lvl4pPr>
      <a:lvl5pPr marL="4334805" algn="l" defTabSz="2167402" rtl="0" eaLnBrk="1" latinLnBrk="0" hangingPunct="1">
        <a:defRPr sz="4267" kern="1200">
          <a:solidFill>
            <a:schemeClr val="tx1"/>
          </a:solidFill>
          <a:latin typeface="+mn-lt"/>
          <a:ea typeface="+mn-ea"/>
          <a:cs typeface="+mn-cs"/>
        </a:defRPr>
      </a:lvl5pPr>
      <a:lvl6pPr marL="5418506" algn="l" defTabSz="2167402" rtl="0" eaLnBrk="1" latinLnBrk="0" hangingPunct="1">
        <a:defRPr sz="4267" kern="1200">
          <a:solidFill>
            <a:schemeClr val="tx1"/>
          </a:solidFill>
          <a:latin typeface="+mn-lt"/>
          <a:ea typeface="+mn-ea"/>
          <a:cs typeface="+mn-cs"/>
        </a:defRPr>
      </a:lvl6pPr>
      <a:lvl7pPr marL="6502207" algn="l" defTabSz="2167402" rtl="0" eaLnBrk="1" latinLnBrk="0" hangingPunct="1">
        <a:defRPr sz="4267" kern="1200">
          <a:solidFill>
            <a:schemeClr val="tx1"/>
          </a:solidFill>
          <a:latin typeface="+mn-lt"/>
          <a:ea typeface="+mn-ea"/>
          <a:cs typeface="+mn-cs"/>
        </a:defRPr>
      </a:lvl7pPr>
      <a:lvl8pPr marL="7585908" algn="l" defTabSz="2167402" rtl="0" eaLnBrk="1" latinLnBrk="0" hangingPunct="1">
        <a:defRPr sz="4267" kern="1200">
          <a:solidFill>
            <a:schemeClr val="tx1"/>
          </a:solidFill>
          <a:latin typeface="+mn-lt"/>
          <a:ea typeface="+mn-ea"/>
          <a:cs typeface="+mn-cs"/>
        </a:defRPr>
      </a:lvl8pPr>
      <a:lvl9pPr marL="8669609" algn="l" defTabSz="2167402" rtl="0" eaLnBrk="1" latinLnBrk="0" hangingPunct="1">
        <a:defRPr sz="426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Table 12">
            <a:extLst>
              <a:ext uri="{FF2B5EF4-FFF2-40B4-BE49-F238E27FC236}">
                <a16:creationId xmlns:a16="http://schemas.microsoft.com/office/drawing/2014/main" id="{CFA702B7-190B-4810-6739-0CA2B2291A9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23282821"/>
              </p:ext>
            </p:extLst>
          </p:nvPr>
        </p:nvGraphicFramePr>
        <p:xfrm>
          <a:off x="2104190" y="19604888"/>
          <a:ext cx="18039756" cy="602191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019878">
                  <a:extLst>
                    <a:ext uri="{9D8B030D-6E8A-4147-A177-3AD203B41FA5}">
                      <a16:colId xmlns:a16="http://schemas.microsoft.com/office/drawing/2014/main" val="2319375248"/>
                    </a:ext>
                  </a:extLst>
                </a:gridCol>
                <a:gridCol w="9019878">
                  <a:extLst>
                    <a:ext uri="{9D8B030D-6E8A-4147-A177-3AD203B41FA5}">
                      <a16:colId xmlns:a16="http://schemas.microsoft.com/office/drawing/2014/main" val="1207842543"/>
                    </a:ext>
                  </a:extLst>
                </a:gridCol>
              </a:tblGrid>
              <a:tr h="453708">
                <a:tc>
                  <a:txBody>
                    <a:bodyPr/>
                    <a:lstStyle/>
                    <a:p>
                      <a:pPr algn="ctr"/>
                      <a:r>
                        <a:rPr lang="fr-FR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+</a:t>
                      </a:r>
                      <a:endParaRPr 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-</a:t>
                      </a:r>
                      <a:endParaRPr 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87540663"/>
                  </a:ext>
                </a:extLst>
              </a:tr>
              <a:tr h="5280173">
                <a:tc>
                  <a:txBody>
                    <a:bodyPr/>
                    <a:lstStyle/>
                    <a:p>
                      <a:pPr algn="ctr"/>
                      <a:endParaRPr 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1807036"/>
                  </a:ext>
                </a:extLst>
              </a:tr>
            </a:tbl>
          </a:graphicData>
        </a:graphic>
      </p:graphicFrame>
      <p:sp>
        <p:nvSpPr>
          <p:cNvPr id="3" name="ZoneTexte 1">
            <a:extLst>
              <a:ext uri="{FF2B5EF4-FFF2-40B4-BE49-F238E27FC236}">
                <a16:creationId xmlns:a16="http://schemas.microsoft.com/office/drawing/2014/main" id="{EF4B28D3-F739-DA0F-7ACB-AD6552D31A3F}"/>
              </a:ext>
            </a:extLst>
          </p:cNvPr>
          <p:cNvSpPr txBox="1"/>
          <p:nvPr/>
        </p:nvSpPr>
        <p:spPr>
          <a:xfrm>
            <a:off x="924393" y="1288607"/>
            <a:ext cx="52610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40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C90BC3B2-BC7A-90D6-8899-9BD768FDD9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19071" y="1496666"/>
            <a:ext cx="8597597" cy="5733881"/>
          </a:xfrm>
          <a:prstGeom prst="rect">
            <a:avLst/>
          </a:prstGeom>
        </p:spPr>
      </p:pic>
      <p:sp>
        <p:nvSpPr>
          <p:cNvPr id="4" name="ZoneTexte 1">
            <a:extLst>
              <a:ext uri="{FF2B5EF4-FFF2-40B4-BE49-F238E27FC236}">
                <a16:creationId xmlns:a16="http://schemas.microsoft.com/office/drawing/2014/main" id="{BD287D1A-BD23-A006-AD0D-15F1A69ABE87}"/>
              </a:ext>
            </a:extLst>
          </p:cNvPr>
          <p:cNvSpPr txBox="1"/>
          <p:nvPr/>
        </p:nvSpPr>
        <p:spPr>
          <a:xfrm>
            <a:off x="924393" y="7184093"/>
            <a:ext cx="52610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40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50" name="Groupe 49">
            <a:extLst>
              <a:ext uri="{FF2B5EF4-FFF2-40B4-BE49-F238E27FC236}">
                <a16:creationId xmlns:a16="http://schemas.microsoft.com/office/drawing/2014/main" id="{2754AA11-9639-F75B-BAC5-2C7F7F45829C}"/>
              </a:ext>
            </a:extLst>
          </p:cNvPr>
          <p:cNvGrpSpPr/>
          <p:nvPr/>
        </p:nvGrpSpPr>
        <p:grpSpPr>
          <a:xfrm>
            <a:off x="2103838" y="17671838"/>
            <a:ext cx="3455048" cy="679152"/>
            <a:chOff x="2094847" y="17623897"/>
            <a:chExt cx="3455048" cy="679152"/>
          </a:xfrm>
        </p:grpSpPr>
        <p:sp>
          <p:nvSpPr>
            <p:cNvPr id="22" name="ZoneTexte 27">
              <a:extLst>
                <a:ext uri="{FF2B5EF4-FFF2-40B4-BE49-F238E27FC236}">
                  <a16:creationId xmlns:a16="http://schemas.microsoft.com/office/drawing/2014/main" id="{A3CD2EFF-9118-F12F-2AED-1D75171A27B3}"/>
                </a:ext>
              </a:extLst>
            </p:cNvPr>
            <p:cNvSpPr txBox="1"/>
            <p:nvPr/>
          </p:nvSpPr>
          <p:spPr>
            <a:xfrm rot="19376873">
              <a:off x="2094847" y="17784768"/>
              <a:ext cx="527615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/>
                <a:t>C1022</a:t>
              </a:r>
            </a:p>
          </p:txBody>
        </p:sp>
        <p:sp>
          <p:nvSpPr>
            <p:cNvPr id="23" name="ZoneTexte 28">
              <a:extLst>
                <a:ext uri="{FF2B5EF4-FFF2-40B4-BE49-F238E27FC236}">
                  <a16:creationId xmlns:a16="http://schemas.microsoft.com/office/drawing/2014/main" id="{394CFC78-0AC8-94DB-99BA-173E13B5A417}"/>
                </a:ext>
              </a:extLst>
            </p:cNvPr>
            <p:cNvSpPr txBox="1"/>
            <p:nvPr/>
          </p:nvSpPr>
          <p:spPr>
            <a:xfrm rot="19294338">
              <a:off x="2917563" y="17769020"/>
              <a:ext cx="465735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/>
                <a:t>C901</a:t>
              </a:r>
            </a:p>
          </p:txBody>
        </p:sp>
        <p:sp>
          <p:nvSpPr>
            <p:cNvPr id="24" name="ZoneTexte 29">
              <a:extLst>
                <a:ext uri="{FF2B5EF4-FFF2-40B4-BE49-F238E27FC236}">
                  <a16:creationId xmlns:a16="http://schemas.microsoft.com/office/drawing/2014/main" id="{7590BD8F-7E42-EE4C-9A7D-99376EABB6D8}"/>
                </a:ext>
              </a:extLst>
            </p:cNvPr>
            <p:cNvSpPr txBox="1"/>
            <p:nvPr/>
          </p:nvSpPr>
          <p:spPr>
            <a:xfrm rot="19097700">
              <a:off x="3710483" y="17777267"/>
              <a:ext cx="471382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 dirty="0"/>
                <a:t>G266</a:t>
              </a:r>
            </a:p>
          </p:txBody>
        </p:sp>
        <p:sp>
          <p:nvSpPr>
            <p:cNvPr id="25" name="ZoneTexte 30">
              <a:extLst>
                <a:ext uri="{FF2B5EF4-FFF2-40B4-BE49-F238E27FC236}">
                  <a16:creationId xmlns:a16="http://schemas.microsoft.com/office/drawing/2014/main" id="{983CBDC5-13CB-0FCA-3189-36218AC970DB}"/>
                </a:ext>
              </a:extLst>
            </p:cNvPr>
            <p:cNvSpPr txBox="1"/>
            <p:nvPr/>
          </p:nvSpPr>
          <p:spPr>
            <a:xfrm rot="18922973">
              <a:off x="4324561" y="17854197"/>
              <a:ext cx="675845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/>
                <a:t>PCU-012</a:t>
              </a:r>
            </a:p>
          </p:txBody>
        </p:sp>
        <p:sp>
          <p:nvSpPr>
            <p:cNvPr id="26" name="ZoneTexte 31">
              <a:extLst>
                <a:ext uri="{FF2B5EF4-FFF2-40B4-BE49-F238E27FC236}">
                  <a16:creationId xmlns:a16="http://schemas.microsoft.com/office/drawing/2014/main" id="{437F8D79-9E0C-FEF7-B298-51B4494F1029}"/>
                </a:ext>
              </a:extLst>
            </p:cNvPr>
            <p:cNvSpPr txBox="1"/>
            <p:nvPr/>
          </p:nvSpPr>
          <p:spPr>
            <a:xfrm rot="18834489">
              <a:off x="5106445" y="17859598"/>
              <a:ext cx="679152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/>
                <a:t>PCU-018</a:t>
              </a:r>
            </a:p>
          </p:txBody>
        </p:sp>
      </p:grpSp>
      <p:pic>
        <p:nvPicPr>
          <p:cNvPr id="52" name="Image 4">
            <a:extLst>
              <a:ext uri="{FF2B5EF4-FFF2-40B4-BE49-F238E27FC236}">
                <a16:creationId xmlns:a16="http://schemas.microsoft.com/office/drawing/2014/main" id="{584D07CA-67B3-6818-440D-E4B7CA5CF74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3249" t="43077" r="-103" b="37747"/>
          <a:stretch/>
        </p:blipFill>
        <p:spPr>
          <a:xfrm>
            <a:off x="13221120" y="16244780"/>
            <a:ext cx="897273" cy="1469862"/>
          </a:xfrm>
          <a:prstGeom prst="rect">
            <a:avLst/>
          </a:prstGeom>
        </p:spPr>
      </p:pic>
      <p:sp>
        <p:nvSpPr>
          <p:cNvPr id="76" name="ZoneTexte 27">
            <a:extLst>
              <a:ext uri="{FF2B5EF4-FFF2-40B4-BE49-F238E27FC236}">
                <a16:creationId xmlns:a16="http://schemas.microsoft.com/office/drawing/2014/main" id="{BD4E4FF7-EE4B-526A-4351-DCB4BE964BC0}"/>
              </a:ext>
            </a:extLst>
          </p:cNvPr>
          <p:cNvSpPr txBox="1"/>
          <p:nvPr/>
        </p:nvSpPr>
        <p:spPr>
          <a:xfrm>
            <a:off x="3839749" y="7968109"/>
            <a:ext cx="342153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fr-FR" dirty="0"/>
              <a:t>AR</a:t>
            </a:r>
          </a:p>
        </p:txBody>
      </p:sp>
      <p:sp>
        <p:nvSpPr>
          <p:cNvPr id="77" name="ZoneTexte 27">
            <a:extLst>
              <a:ext uri="{FF2B5EF4-FFF2-40B4-BE49-F238E27FC236}">
                <a16:creationId xmlns:a16="http://schemas.microsoft.com/office/drawing/2014/main" id="{CCBBA386-5F72-853B-353C-1648AC79B47E}"/>
              </a:ext>
            </a:extLst>
          </p:cNvPr>
          <p:cNvSpPr txBox="1"/>
          <p:nvPr/>
        </p:nvSpPr>
        <p:spPr>
          <a:xfrm>
            <a:off x="8521735" y="7968108"/>
            <a:ext cx="618762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fr-FR" dirty="0"/>
              <a:t>PEG10</a:t>
            </a:r>
          </a:p>
        </p:txBody>
      </p:sp>
      <p:sp>
        <p:nvSpPr>
          <p:cNvPr id="78" name="ZoneTexte 27">
            <a:extLst>
              <a:ext uri="{FF2B5EF4-FFF2-40B4-BE49-F238E27FC236}">
                <a16:creationId xmlns:a16="http://schemas.microsoft.com/office/drawing/2014/main" id="{5337C063-4790-A93A-1A44-26F1D7A14BE8}"/>
              </a:ext>
            </a:extLst>
          </p:cNvPr>
          <p:cNvSpPr txBox="1"/>
          <p:nvPr/>
        </p:nvSpPr>
        <p:spPr>
          <a:xfrm>
            <a:off x="13499631" y="7968107"/>
            <a:ext cx="618762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fr-FR"/>
              <a:t>MYCN</a:t>
            </a:r>
          </a:p>
        </p:txBody>
      </p:sp>
      <p:sp>
        <p:nvSpPr>
          <p:cNvPr id="79" name="ZoneTexte 27">
            <a:extLst>
              <a:ext uri="{FF2B5EF4-FFF2-40B4-BE49-F238E27FC236}">
                <a16:creationId xmlns:a16="http://schemas.microsoft.com/office/drawing/2014/main" id="{1EB5CA05-0A33-9047-6E02-159FCAB560FC}"/>
              </a:ext>
            </a:extLst>
          </p:cNvPr>
          <p:cNvSpPr txBox="1"/>
          <p:nvPr/>
        </p:nvSpPr>
        <p:spPr>
          <a:xfrm>
            <a:off x="18389944" y="7968106"/>
            <a:ext cx="526106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fr-FR"/>
              <a:t>EZH2</a:t>
            </a:r>
          </a:p>
        </p:txBody>
      </p:sp>
      <p:sp>
        <p:nvSpPr>
          <p:cNvPr id="80" name="ZoneTexte 27">
            <a:extLst>
              <a:ext uri="{FF2B5EF4-FFF2-40B4-BE49-F238E27FC236}">
                <a16:creationId xmlns:a16="http://schemas.microsoft.com/office/drawing/2014/main" id="{795EE4A7-0B87-1DFF-1948-3E750549714A}"/>
              </a:ext>
            </a:extLst>
          </p:cNvPr>
          <p:cNvSpPr txBox="1"/>
          <p:nvPr/>
        </p:nvSpPr>
        <p:spPr>
          <a:xfrm>
            <a:off x="18389944" y="11361247"/>
            <a:ext cx="526106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fr-FR"/>
              <a:t>CDH2</a:t>
            </a:r>
          </a:p>
        </p:txBody>
      </p:sp>
      <p:sp>
        <p:nvSpPr>
          <p:cNvPr id="81" name="ZoneTexte 27">
            <a:extLst>
              <a:ext uri="{FF2B5EF4-FFF2-40B4-BE49-F238E27FC236}">
                <a16:creationId xmlns:a16="http://schemas.microsoft.com/office/drawing/2014/main" id="{2DC3C10F-A37A-8DB6-3BE9-64A5850A9FAF}"/>
              </a:ext>
            </a:extLst>
          </p:cNvPr>
          <p:cNvSpPr txBox="1"/>
          <p:nvPr/>
        </p:nvSpPr>
        <p:spPr>
          <a:xfrm>
            <a:off x="13565143" y="11361246"/>
            <a:ext cx="526106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fr-FR"/>
              <a:t>TP53</a:t>
            </a:r>
          </a:p>
        </p:txBody>
      </p:sp>
      <p:sp>
        <p:nvSpPr>
          <p:cNvPr id="82" name="ZoneTexte 27">
            <a:extLst>
              <a:ext uri="{FF2B5EF4-FFF2-40B4-BE49-F238E27FC236}">
                <a16:creationId xmlns:a16="http://schemas.microsoft.com/office/drawing/2014/main" id="{A6F1F30E-BD3E-4B73-C7C2-68A03A96D839}"/>
              </a:ext>
            </a:extLst>
          </p:cNvPr>
          <p:cNvSpPr txBox="1"/>
          <p:nvPr/>
        </p:nvSpPr>
        <p:spPr>
          <a:xfrm>
            <a:off x="8518010" y="11361245"/>
            <a:ext cx="763482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fr-FR" dirty="0"/>
              <a:t>POU3F2</a:t>
            </a:r>
          </a:p>
        </p:txBody>
      </p:sp>
      <p:sp>
        <p:nvSpPr>
          <p:cNvPr id="83" name="ZoneTexte 27">
            <a:extLst>
              <a:ext uri="{FF2B5EF4-FFF2-40B4-BE49-F238E27FC236}">
                <a16:creationId xmlns:a16="http://schemas.microsoft.com/office/drawing/2014/main" id="{3154FD4E-4FD1-2E68-85FD-8A27BB611930}"/>
              </a:ext>
            </a:extLst>
          </p:cNvPr>
          <p:cNvSpPr txBox="1"/>
          <p:nvPr/>
        </p:nvSpPr>
        <p:spPr>
          <a:xfrm>
            <a:off x="8635890" y="14695126"/>
            <a:ext cx="532039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fr-FR"/>
              <a:t>SOX2</a:t>
            </a:r>
          </a:p>
        </p:txBody>
      </p:sp>
      <p:sp>
        <p:nvSpPr>
          <p:cNvPr id="84" name="ZoneTexte 27">
            <a:extLst>
              <a:ext uri="{FF2B5EF4-FFF2-40B4-BE49-F238E27FC236}">
                <a16:creationId xmlns:a16="http://schemas.microsoft.com/office/drawing/2014/main" id="{39838195-7AFC-2CF3-A98E-4B3CBD09CC46}"/>
              </a:ext>
            </a:extLst>
          </p:cNvPr>
          <p:cNvSpPr txBox="1"/>
          <p:nvPr/>
        </p:nvSpPr>
        <p:spPr>
          <a:xfrm>
            <a:off x="3699258" y="11361245"/>
            <a:ext cx="401103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fr-FR" dirty="0"/>
              <a:t>RB1</a:t>
            </a:r>
          </a:p>
        </p:txBody>
      </p:sp>
      <p:sp>
        <p:nvSpPr>
          <p:cNvPr id="85" name="ZoneTexte 27">
            <a:extLst>
              <a:ext uri="{FF2B5EF4-FFF2-40B4-BE49-F238E27FC236}">
                <a16:creationId xmlns:a16="http://schemas.microsoft.com/office/drawing/2014/main" id="{F497A063-6EA5-3D0C-B9EB-87298D00E6F1}"/>
              </a:ext>
            </a:extLst>
          </p:cNvPr>
          <p:cNvSpPr txBox="1"/>
          <p:nvPr/>
        </p:nvSpPr>
        <p:spPr>
          <a:xfrm>
            <a:off x="3633789" y="14694907"/>
            <a:ext cx="532039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fr-FR" dirty="0"/>
              <a:t>REST</a:t>
            </a:r>
          </a:p>
        </p:txBody>
      </p:sp>
      <p:sp>
        <p:nvSpPr>
          <p:cNvPr id="87" name="ZoneTexte 1">
            <a:extLst>
              <a:ext uri="{FF2B5EF4-FFF2-40B4-BE49-F238E27FC236}">
                <a16:creationId xmlns:a16="http://schemas.microsoft.com/office/drawing/2014/main" id="{6CD8B660-A682-1532-7775-8F1D6938170C}"/>
              </a:ext>
            </a:extLst>
          </p:cNvPr>
          <p:cNvSpPr txBox="1"/>
          <p:nvPr/>
        </p:nvSpPr>
        <p:spPr>
          <a:xfrm>
            <a:off x="924393" y="18364280"/>
            <a:ext cx="55496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400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0" name="ZoneTexte 27">
            <a:extLst>
              <a:ext uri="{FF2B5EF4-FFF2-40B4-BE49-F238E27FC236}">
                <a16:creationId xmlns:a16="http://schemas.microsoft.com/office/drawing/2014/main" id="{94A21F0C-637A-03A6-968E-6952D0147BB3}"/>
              </a:ext>
            </a:extLst>
          </p:cNvPr>
          <p:cNvSpPr txBox="1"/>
          <p:nvPr/>
        </p:nvSpPr>
        <p:spPr>
          <a:xfrm>
            <a:off x="3236999" y="20734712"/>
            <a:ext cx="6879897" cy="49244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fr-FR" sz="3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901		G266	PCU-012		PCU-018	</a:t>
            </a:r>
          </a:p>
        </p:txBody>
      </p:sp>
      <p:sp>
        <p:nvSpPr>
          <p:cNvPr id="101" name="ZoneTexte 27">
            <a:extLst>
              <a:ext uri="{FF2B5EF4-FFF2-40B4-BE49-F238E27FC236}">
                <a16:creationId xmlns:a16="http://schemas.microsoft.com/office/drawing/2014/main" id="{946DBEDC-ABA7-63E3-F5D7-041CDB725434}"/>
              </a:ext>
            </a:extLst>
          </p:cNvPr>
          <p:cNvSpPr txBox="1"/>
          <p:nvPr/>
        </p:nvSpPr>
        <p:spPr>
          <a:xfrm>
            <a:off x="15011898" y="20733599"/>
            <a:ext cx="1358585" cy="49244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fr-FR" sz="3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1022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6CFBA2CE-064E-7615-AC95-98E3A2664F57}"/>
              </a:ext>
            </a:extLst>
          </p:cNvPr>
          <p:cNvGrpSpPr/>
          <p:nvPr/>
        </p:nvGrpSpPr>
        <p:grpSpPr>
          <a:xfrm>
            <a:off x="2569789" y="21502905"/>
            <a:ext cx="7740378" cy="3249663"/>
            <a:chOff x="1181967" y="20632970"/>
            <a:chExt cx="7740378" cy="3249663"/>
          </a:xfrm>
        </p:grpSpPr>
        <p:pic>
          <p:nvPicPr>
            <p:cNvPr id="96" name="Picture 95">
              <a:extLst>
                <a:ext uri="{FF2B5EF4-FFF2-40B4-BE49-F238E27FC236}">
                  <a16:creationId xmlns:a16="http://schemas.microsoft.com/office/drawing/2014/main" id="{078CDA1E-8441-231F-C0D4-9109AC3E931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81967" y="20632970"/>
              <a:ext cx="2405700" cy="3240000"/>
            </a:xfrm>
            <a:prstGeom prst="rect">
              <a:avLst/>
            </a:prstGeom>
          </p:spPr>
        </p:pic>
        <p:pic>
          <p:nvPicPr>
            <p:cNvPr id="97" name="Picture 96">
              <a:extLst>
                <a:ext uri="{FF2B5EF4-FFF2-40B4-BE49-F238E27FC236}">
                  <a16:creationId xmlns:a16="http://schemas.microsoft.com/office/drawing/2014/main" id="{AF23388F-220B-1BC9-59B2-96C463445AD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516645" y="20642633"/>
              <a:ext cx="2405700" cy="3240000"/>
            </a:xfrm>
            <a:prstGeom prst="rect">
              <a:avLst/>
            </a:prstGeom>
          </p:spPr>
        </p:pic>
        <p:pic>
          <p:nvPicPr>
            <p:cNvPr id="98" name="Picture 97">
              <a:extLst>
                <a:ext uri="{FF2B5EF4-FFF2-40B4-BE49-F238E27FC236}">
                  <a16:creationId xmlns:a16="http://schemas.microsoft.com/office/drawing/2014/main" id="{26F9EF65-ADA1-E4D0-2600-BFFDFB51133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965366" y="20632970"/>
              <a:ext cx="2405700" cy="3240000"/>
            </a:xfrm>
            <a:prstGeom prst="rect">
              <a:avLst/>
            </a:prstGeom>
          </p:spPr>
        </p:pic>
        <p:sp>
          <p:nvSpPr>
            <p:cNvPr id="102" name="ZoneTexte 27">
              <a:extLst>
                <a:ext uri="{FF2B5EF4-FFF2-40B4-BE49-F238E27FC236}">
                  <a16:creationId xmlns:a16="http://schemas.microsoft.com/office/drawing/2014/main" id="{361861FD-F844-1633-C99B-32CACD03D201}"/>
                </a:ext>
              </a:extLst>
            </p:cNvPr>
            <p:cNvSpPr txBox="1"/>
            <p:nvPr/>
          </p:nvSpPr>
          <p:spPr>
            <a:xfrm>
              <a:off x="1785712" y="22789798"/>
              <a:ext cx="2034075" cy="73866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2400"/>
                <a:t>NES= 2.08</a:t>
              </a:r>
            </a:p>
            <a:p>
              <a:r>
                <a:rPr lang="fr-FR" sz="2400" i="1"/>
                <a:t>p</a:t>
              </a:r>
              <a:r>
                <a:rPr lang="fr-FR" sz="2400"/>
                <a:t>= 1.31</a:t>
              </a:r>
              <a:r>
                <a:rPr lang="fr-FR" sz="2400" baseline="30000"/>
                <a:t>-7</a:t>
              </a:r>
            </a:p>
          </p:txBody>
        </p:sp>
        <p:sp>
          <p:nvSpPr>
            <p:cNvPr id="103" name="ZoneTexte 27">
              <a:extLst>
                <a:ext uri="{FF2B5EF4-FFF2-40B4-BE49-F238E27FC236}">
                  <a16:creationId xmlns:a16="http://schemas.microsoft.com/office/drawing/2014/main" id="{A1EC6742-041D-0231-0CD6-61A7C34DC6D7}"/>
                </a:ext>
              </a:extLst>
            </p:cNvPr>
            <p:cNvSpPr txBox="1"/>
            <p:nvPr/>
          </p:nvSpPr>
          <p:spPr>
            <a:xfrm>
              <a:off x="4598359" y="22789798"/>
              <a:ext cx="1348252" cy="73866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2400"/>
                <a:t>NES= 1.4</a:t>
              </a:r>
            </a:p>
            <a:p>
              <a:r>
                <a:rPr lang="fr-FR" sz="2400" i="1"/>
                <a:t>p</a:t>
              </a:r>
              <a:r>
                <a:rPr lang="fr-FR" sz="2400"/>
                <a:t>= 0,008</a:t>
              </a:r>
              <a:endParaRPr lang="fr-FR" sz="2400" baseline="30000"/>
            </a:p>
          </p:txBody>
        </p:sp>
        <p:sp>
          <p:nvSpPr>
            <p:cNvPr id="104" name="ZoneTexte 27">
              <a:extLst>
                <a:ext uri="{FF2B5EF4-FFF2-40B4-BE49-F238E27FC236}">
                  <a16:creationId xmlns:a16="http://schemas.microsoft.com/office/drawing/2014/main" id="{3B3F6148-86F9-B502-BAA6-1389F4DA76AE}"/>
                </a:ext>
              </a:extLst>
            </p:cNvPr>
            <p:cNvSpPr txBox="1"/>
            <p:nvPr/>
          </p:nvSpPr>
          <p:spPr>
            <a:xfrm>
              <a:off x="7252925" y="22764538"/>
              <a:ext cx="1348252" cy="73866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2400"/>
                <a:t>NES= 1.7</a:t>
              </a:r>
            </a:p>
            <a:p>
              <a:r>
                <a:rPr lang="fr-FR" sz="2400" i="1"/>
                <a:t>p</a:t>
              </a:r>
              <a:r>
                <a:rPr lang="fr-FR" sz="2400"/>
                <a:t>= 5.39</a:t>
              </a:r>
              <a:r>
                <a:rPr lang="fr-FR" sz="2400" baseline="30000"/>
                <a:t>-5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0B7C156C-957A-3B2A-801E-CF9AF1AE6428}"/>
              </a:ext>
            </a:extLst>
          </p:cNvPr>
          <p:cNvGrpSpPr/>
          <p:nvPr/>
        </p:nvGrpSpPr>
        <p:grpSpPr>
          <a:xfrm>
            <a:off x="11316668" y="21438668"/>
            <a:ext cx="8491556" cy="3240000"/>
            <a:chOff x="12102259" y="24537698"/>
            <a:chExt cx="8491556" cy="3240000"/>
          </a:xfrm>
        </p:grpSpPr>
        <p:pic>
          <p:nvPicPr>
            <p:cNvPr id="91" name="Picture 90">
              <a:extLst>
                <a:ext uri="{FF2B5EF4-FFF2-40B4-BE49-F238E27FC236}">
                  <a16:creationId xmlns:a16="http://schemas.microsoft.com/office/drawing/2014/main" id="{DC126256-9247-0157-BD33-136582D0884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4929139" y="24537698"/>
              <a:ext cx="2405700" cy="3240000"/>
            </a:xfrm>
            <a:prstGeom prst="rect">
              <a:avLst/>
            </a:prstGeom>
          </p:spPr>
        </p:pic>
        <p:pic>
          <p:nvPicPr>
            <p:cNvPr id="92" name="Picture 91">
              <a:extLst>
                <a:ext uri="{FF2B5EF4-FFF2-40B4-BE49-F238E27FC236}">
                  <a16:creationId xmlns:a16="http://schemas.microsoft.com/office/drawing/2014/main" id="{483DEF6D-A59A-EC61-B245-9AA63898571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7848174" y="24537698"/>
              <a:ext cx="2405700" cy="3240000"/>
            </a:xfrm>
            <a:prstGeom prst="rect">
              <a:avLst/>
            </a:prstGeom>
          </p:spPr>
        </p:pic>
        <p:pic>
          <p:nvPicPr>
            <p:cNvPr id="93" name="Picture 92">
              <a:extLst>
                <a:ext uri="{FF2B5EF4-FFF2-40B4-BE49-F238E27FC236}">
                  <a16:creationId xmlns:a16="http://schemas.microsoft.com/office/drawing/2014/main" id="{0BF725DF-29A7-CF8C-45C3-B0A82248ECD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2102259" y="24537698"/>
              <a:ext cx="2405700" cy="3240000"/>
            </a:xfrm>
            <a:prstGeom prst="rect">
              <a:avLst/>
            </a:prstGeom>
          </p:spPr>
        </p:pic>
        <p:sp>
          <p:nvSpPr>
            <p:cNvPr id="108" name="ZoneTexte 27">
              <a:extLst>
                <a:ext uri="{FF2B5EF4-FFF2-40B4-BE49-F238E27FC236}">
                  <a16:creationId xmlns:a16="http://schemas.microsoft.com/office/drawing/2014/main" id="{07048B84-0211-A3CC-8887-6054823E51DE}"/>
                </a:ext>
              </a:extLst>
            </p:cNvPr>
            <p:cNvSpPr txBox="1"/>
            <p:nvPr/>
          </p:nvSpPr>
          <p:spPr>
            <a:xfrm>
              <a:off x="12783735" y="26663520"/>
              <a:ext cx="2034075" cy="73866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2400"/>
                <a:t>NES= -1,83</a:t>
              </a:r>
            </a:p>
            <a:p>
              <a:r>
                <a:rPr lang="fr-FR" sz="2400" i="1"/>
                <a:t>p</a:t>
              </a:r>
              <a:r>
                <a:rPr lang="fr-FR" sz="2400"/>
                <a:t>= 2.4</a:t>
              </a:r>
              <a:r>
                <a:rPr lang="fr-FR" sz="2400" baseline="30000"/>
                <a:t>-6</a:t>
              </a:r>
            </a:p>
          </p:txBody>
        </p:sp>
        <p:sp>
          <p:nvSpPr>
            <p:cNvPr id="109" name="ZoneTexte 27">
              <a:extLst>
                <a:ext uri="{FF2B5EF4-FFF2-40B4-BE49-F238E27FC236}">
                  <a16:creationId xmlns:a16="http://schemas.microsoft.com/office/drawing/2014/main" id="{4609674A-3B75-E2CB-7BBB-9EF6E5F5B2D6}"/>
                </a:ext>
              </a:extLst>
            </p:cNvPr>
            <p:cNvSpPr txBox="1"/>
            <p:nvPr/>
          </p:nvSpPr>
          <p:spPr>
            <a:xfrm>
              <a:off x="15636983" y="26663520"/>
              <a:ext cx="2034075" cy="73866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2400"/>
                <a:t>NES= -1,88</a:t>
              </a:r>
            </a:p>
            <a:p>
              <a:r>
                <a:rPr lang="fr-FR" sz="2400" i="1"/>
                <a:t>p</a:t>
              </a:r>
              <a:r>
                <a:rPr lang="fr-FR" sz="2400"/>
                <a:t>= 1.48</a:t>
              </a:r>
              <a:r>
                <a:rPr lang="fr-FR" sz="2400" baseline="30000"/>
                <a:t>-7</a:t>
              </a:r>
            </a:p>
          </p:txBody>
        </p:sp>
        <p:sp>
          <p:nvSpPr>
            <p:cNvPr id="110" name="ZoneTexte 27">
              <a:extLst>
                <a:ext uri="{FF2B5EF4-FFF2-40B4-BE49-F238E27FC236}">
                  <a16:creationId xmlns:a16="http://schemas.microsoft.com/office/drawing/2014/main" id="{9B6047CD-BE36-C4C4-CA38-A6DF9B3D4225}"/>
                </a:ext>
              </a:extLst>
            </p:cNvPr>
            <p:cNvSpPr txBox="1"/>
            <p:nvPr/>
          </p:nvSpPr>
          <p:spPr>
            <a:xfrm>
              <a:off x="18559740" y="26663520"/>
              <a:ext cx="2034075" cy="73866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2400"/>
                <a:t>NES= -1,91</a:t>
              </a:r>
            </a:p>
            <a:p>
              <a:r>
                <a:rPr lang="fr-FR" sz="2400" i="1"/>
                <a:t>p</a:t>
              </a:r>
              <a:r>
                <a:rPr lang="fr-FR" sz="2400"/>
                <a:t>= 1.10</a:t>
              </a:r>
              <a:r>
                <a:rPr lang="fr-FR" sz="2400" baseline="30000"/>
                <a:t>-7</a:t>
              </a:r>
            </a:p>
          </p:txBody>
        </p:sp>
      </p:grpSp>
      <p:pic>
        <p:nvPicPr>
          <p:cNvPr id="5" name="Image 4">
            <a:extLst>
              <a:ext uri="{FF2B5EF4-FFF2-40B4-BE49-F238E27FC236}">
                <a16:creationId xmlns:a16="http://schemas.microsoft.com/office/drawing/2014/main" id="{CD80D16C-CF23-6EC6-51D4-4FB749277FAC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78" r="7019" b="5247"/>
          <a:stretch/>
        </p:blipFill>
        <p:spPr>
          <a:xfrm>
            <a:off x="1625241" y="8210405"/>
            <a:ext cx="4543542" cy="2744061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DF216562-E806-7CBA-F2B0-0FCFDFB8624F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400" r="7170" b="5336"/>
          <a:stretch/>
        </p:blipFill>
        <p:spPr>
          <a:xfrm>
            <a:off x="6382801" y="8210405"/>
            <a:ext cx="4619254" cy="2744061"/>
          </a:xfrm>
          <a:prstGeom prst="rect">
            <a:avLst/>
          </a:prstGeom>
        </p:spPr>
      </p:pic>
      <p:pic>
        <p:nvPicPr>
          <p:cNvPr id="29" name="Image 28" descr="Une image contenant table&#10;&#10;Description générée automatiquement">
            <a:extLst>
              <a:ext uri="{FF2B5EF4-FFF2-40B4-BE49-F238E27FC236}">
                <a16:creationId xmlns:a16="http://schemas.microsoft.com/office/drawing/2014/main" id="{C27F9FEC-F2F1-5279-6180-16C5E7909240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73" r="7170" b="5337"/>
          <a:stretch/>
        </p:blipFill>
        <p:spPr>
          <a:xfrm>
            <a:off x="11318560" y="8210641"/>
            <a:ext cx="4543542" cy="2744062"/>
          </a:xfrm>
          <a:prstGeom prst="rect">
            <a:avLst/>
          </a:prstGeom>
        </p:spPr>
      </p:pic>
      <p:pic>
        <p:nvPicPr>
          <p:cNvPr id="31" name="Image 30">
            <a:extLst>
              <a:ext uri="{FF2B5EF4-FFF2-40B4-BE49-F238E27FC236}">
                <a16:creationId xmlns:a16="http://schemas.microsoft.com/office/drawing/2014/main" id="{7ECCC5A5-692E-3089-2F0B-28389ED27EEA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400" r="7170" b="5336"/>
          <a:stretch/>
        </p:blipFill>
        <p:spPr>
          <a:xfrm>
            <a:off x="16181108" y="8210364"/>
            <a:ext cx="4619255" cy="2744102"/>
          </a:xfrm>
          <a:prstGeom prst="rect">
            <a:avLst/>
          </a:prstGeom>
        </p:spPr>
      </p:pic>
      <p:pic>
        <p:nvPicPr>
          <p:cNvPr id="33" name="Image 32">
            <a:extLst>
              <a:ext uri="{FF2B5EF4-FFF2-40B4-BE49-F238E27FC236}">
                <a16:creationId xmlns:a16="http://schemas.microsoft.com/office/drawing/2014/main" id="{05B71A34-9B0E-42C1-FB39-84432C33B875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817" r="7356" b="5419"/>
          <a:stretch/>
        </p:blipFill>
        <p:spPr>
          <a:xfrm>
            <a:off x="1625241" y="11644713"/>
            <a:ext cx="4619254" cy="2744065"/>
          </a:xfrm>
          <a:prstGeom prst="rect">
            <a:avLst/>
          </a:prstGeom>
        </p:spPr>
      </p:pic>
      <p:pic>
        <p:nvPicPr>
          <p:cNvPr id="35" name="Image 34" descr="Une image contenant table&#10;&#10;Description générée automatiquement">
            <a:extLst>
              <a:ext uri="{FF2B5EF4-FFF2-40B4-BE49-F238E27FC236}">
                <a16:creationId xmlns:a16="http://schemas.microsoft.com/office/drawing/2014/main" id="{1EF69010-95DD-9170-2E69-4AD8CF0D6506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01" r="7359" b="5340"/>
          <a:stretch/>
        </p:blipFill>
        <p:spPr>
          <a:xfrm>
            <a:off x="6426144" y="11639974"/>
            <a:ext cx="4543543" cy="2744065"/>
          </a:xfrm>
          <a:prstGeom prst="rect">
            <a:avLst/>
          </a:prstGeom>
        </p:spPr>
      </p:pic>
      <p:pic>
        <p:nvPicPr>
          <p:cNvPr id="37" name="Image 36">
            <a:extLst>
              <a:ext uri="{FF2B5EF4-FFF2-40B4-BE49-F238E27FC236}">
                <a16:creationId xmlns:a16="http://schemas.microsoft.com/office/drawing/2014/main" id="{DAC62688-2693-AC28-7EE3-732A495A0BFD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19" r="7170" b="5336"/>
          <a:stretch/>
        </p:blipFill>
        <p:spPr>
          <a:xfrm>
            <a:off x="11345521" y="11650726"/>
            <a:ext cx="4543544" cy="2744067"/>
          </a:xfrm>
          <a:prstGeom prst="rect">
            <a:avLst/>
          </a:prstGeom>
        </p:spPr>
      </p:pic>
      <p:pic>
        <p:nvPicPr>
          <p:cNvPr id="39" name="Image 38" descr="Une image contenant table&#10;&#10;Description générée automatiquement">
            <a:extLst>
              <a:ext uri="{FF2B5EF4-FFF2-40B4-BE49-F238E27FC236}">
                <a16:creationId xmlns:a16="http://schemas.microsoft.com/office/drawing/2014/main" id="{14D1C300-5D2F-0149-DE01-FE8BA6A2C74E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400" r="7170" b="5336"/>
          <a:stretch/>
        </p:blipFill>
        <p:spPr>
          <a:xfrm>
            <a:off x="16181109" y="11636966"/>
            <a:ext cx="4619254" cy="2744067"/>
          </a:xfrm>
          <a:prstGeom prst="rect">
            <a:avLst/>
          </a:prstGeom>
        </p:spPr>
      </p:pic>
      <p:pic>
        <p:nvPicPr>
          <p:cNvPr id="41" name="Image 40">
            <a:extLst>
              <a:ext uri="{FF2B5EF4-FFF2-40B4-BE49-F238E27FC236}">
                <a16:creationId xmlns:a16="http://schemas.microsoft.com/office/drawing/2014/main" id="{1E92BADA-C0C2-93E5-28A9-EED698CDC179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840" r="7454" b="5916"/>
          <a:stretch/>
        </p:blipFill>
        <p:spPr>
          <a:xfrm>
            <a:off x="1620135" y="14939221"/>
            <a:ext cx="4543544" cy="2744067"/>
          </a:xfrm>
          <a:prstGeom prst="rect">
            <a:avLst/>
          </a:prstGeom>
        </p:spPr>
      </p:pic>
      <p:pic>
        <p:nvPicPr>
          <p:cNvPr id="43" name="Image 42">
            <a:extLst>
              <a:ext uri="{FF2B5EF4-FFF2-40B4-BE49-F238E27FC236}">
                <a16:creationId xmlns:a16="http://schemas.microsoft.com/office/drawing/2014/main" id="{92FA55D0-10E0-0882-49C2-12384B4AB057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841" r="6880" b="6027"/>
          <a:stretch/>
        </p:blipFill>
        <p:spPr>
          <a:xfrm>
            <a:off x="6426144" y="14942177"/>
            <a:ext cx="4543543" cy="2744068"/>
          </a:xfrm>
          <a:prstGeom prst="rect">
            <a:avLst/>
          </a:prstGeom>
        </p:spPr>
      </p:pic>
      <p:grpSp>
        <p:nvGrpSpPr>
          <p:cNvPr id="49" name="Groupe 48">
            <a:extLst>
              <a:ext uri="{FF2B5EF4-FFF2-40B4-BE49-F238E27FC236}">
                <a16:creationId xmlns:a16="http://schemas.microsoft.com/office/drawing/2014/main" id="{DF75FC37-6DB0-E84A-0AC6-511DC3F500A9}"/>
              </a:ext>
            </a:extLst>
          </p:cNvPr>
          <p:cNvGrpSpPr/>
          <p:nvPr/>
        </p:nvGrpSpPr>
        <p:grpSpPr>
          <a:xfrm>
            <a:off x="6833467" y="17681080"/>
            <a:ext cx="3455048" cy="679152"/>
            <a:chOff x="2247247" y="17776297"/>
            <a:chExt cx="3455048" cy="679152"/>
          </a:xfrm>
        </p:grpSpPr>
        <p:sp>
          <p:nvSpPr>
            <p:cNvPr id="44" name="ZoneTexte 27">
              <a:extLst>
                <a:ext uri="{FF2B5EF4-FFF2-40B4-BE49-F238E27FC236}">
                  <a16:creationId xmlns:a16="http://schemas.microsoft.com/office/drawing/2014/main" id="{97D18499-94DA-291D-0A61-FE66AE67FD37}"/>
                </a:ext>
              </a:extLst>
            </p:cNvPr>
            <p:cNvSpPr txBox="1"/>
            <p:nvPr/>
          </p:nvSpPr>
          <p:spPr>
            <a:xfrm rot="19376873">
              <a:off x="2247247" y="17937168"/>
              <a:ext cx="527615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/>
                <a:t>C1022</a:t>
              </a:r>
            </a:p>
          </p:txBody>
        </p:sp>
        <p:sp>
          <p:nvSpPr>
            <p:cNvPr id="45" name="ZoneTexte 28">
              <a:extLst>
                <a:ext uri="{FF2B5EF4-FFF2-40B4-BE49-F238E27FC236}">
                  <a16:creationId xmlns:a16="http://schemas.microsoft.com/office/drawing/2014/main" id="{DDB88E1D-093D-6696-2D79-D7863FE5B534}"/>
                </a:ext>
              </a:extLst>
            </p:cNvPr>
            <p:cNvSpPr txBox="1"/>
            <p:nvPr/>
          </p:nvSpPr>
          <p:spPr>
            <a:xfrm rot="19294338">
              <a:off x="3069963" y="17921420"/>
              <a:ext cx="465735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/>
                <a:t>C901</a:t>
              </a:r>
            </a:p>
          </p:txBody>
        </p:sp>
        <p:sp>
          <p:nvSpPr>
            <p:cNvPr id="46" name="ZoneTexte 29">
              <a:extLst>
                <a:ext uri="{FF2B5EF4-FFF2-40B4-BE49-F238E27FC236}">
                  <a16:creationId xmlns:a16="http://schemas.microsoft.com/office/drawing/2014/main" id="{8FDC612A-6021-D5D9-87AF-3B3718856A30}"/>
                </a:ext>
              </a:extLst>
            </p:cNvPr>
            <p:cNvSpPr txBox="1"/>
            <p:nvPr/>
          </p:nvSpPr>
          <p:spPr>
            <a:xfrm rot="19097700">
              <a:off x="3862883" y="17929667"/>
              <a:ext cx="471382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 dirty="0"/>
                <a:t>G266</a:t>
              </a:r>
            </a:p>
          </p:txBody>
        </p:sp>
        <p:sp>
          <p:nvSpPr>
            <p:cNvPr id="47" name="ZoneTexte 30">
              <a:extLst>
                <a:ext uri="{FF2B5EF4-FFF2-40B4-BE49-F238E27FC236}">
                  <a16:creationId xmlns:a16="http://schemas.microsoft.com/office/drawing/2014/main" id="{CB006067-B8E4-1875-FC95-D762912B06F7}"/>
                </a:ext>
              </a:extLst>
            </p:cNvPr>
            <p:cNvSpPr txBox="1"/>
            <p:nvPr/>
          </p:nvSpPr>
          <p:spPr>
            <a:xfrm rot="18922973">
              <a:off x="4476961" y="18006597"/>
              <a:ext cx="675845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/>
                <a:t>PCU-012</a:t>
              </a:r>
            </a:p>
          </p:txBody>
        </p:sp>
        <p:sp>
          <p:nvSpPr>
            <p:cNvPr id="48" name="ZoneTexte 31">
              <a:extLst>
                <a:ext uri="{FF2B5EF4-FFF2-40B4-BE49-F238E27FC236}">
                  <a16:creationId xmlns:a16="http://schemas.microsoft.com/office/drawing/2014/main" id="{17E71B8C-5E1C-1D2D-EE51-3299C229B259}"/>
                </a:ext>
              </a:extLst>
            </p:cNvPr>
            <p:cNvSpPr txBox="1"/>
            <p:nvPr/>
          </p:nvSpPr>
          <p:spPr>
            <a:xfrm rot="18834489">
              <a:off x="5258845" y="18011998"/>
              <a:ext cx="679152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/>
                <a:t>PCU-018</a:t>
              </a:r>
            </a:p>
          </p:txBody>
        </p:sp>
      </p:grpSp>
      <p:grpSp>
        <p:nvGrpSpPr>
          <p:cNvPr id="51" name="Groupe 50">
            <a:extLst>
              <a:ext uri="{FF2B5EF4-FFF2-40B4-BE49-F238E27FC236}">
                <a16:creationId xmlns:a16="http://schemas.microsoft.com/office/drawing/2014/main" id="{4EEEC4FC-C35E-BDAF-419B-DE4F8AE9C01D}"/>
              </a:ext>
            </a:extLst>
          </p:cNvPr>
          <p:cNvGrpSpPr/>
          <p:nvPr/>
        </p:nvGrpSpPr>
        <p:grpSpPr>
          <a:xfrm>
            <a:off x="11862807" y="14411664"/>
            <a:ext cx="3455048" cy="679152"/>
            <a:chOff x="2094847" y="17623897"/>
            <a:chExt cx="3455048" cy="679152"/>
          </a:xfrm>
        </p:grpSpPr>
        <p:sp>
          <p:nvSpPr>
            <p:cNvPr id="53" name="ZoneTexte 27">
              <a:extLst>
                <a:ext uri="{FF2B5EF4-FFF2-40B4-BE49-F238E27FC236}">
                  <a16:creationId xmlns:a16="http://schemas.microsoft.com/office/drawing/2014/main" id="{8D614749-1D62-1CC4-BD19-611534A74FB4}"/>
                </a:ext>
              </a:extLst>
            </p:cNvPr>
            <p:cNvSpPr txBox="1"/>
            <p:nvPr/>
          </p:nvSpPr>
          <p:spPr>
            <a:xfrm rot="19376873">
              <a:off x="2094847" y="17784768"/>
              <a:ext cx="527615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/>
                <a:t>C1022</a:t>
              </a:r>
            </a:p>
          </p:txBody>
        </p:sp>
        <p:sp>
          <p:nvSpPr>
            <p:cNvPr id="54" name="ZoneTexte 28">
              <a:extLst>
                <a:ext uri="{FF2B5EF4-FFF2-40B4-BE49-F238E27FC236}">
                  <a16:creationId xmlns:a16="http://schemas.microsoft.com/office/drawing/2014/main" id="{EC455DF1-3474-4379-AFE6-619C4794B8EB}"/>
                </a:ext>
              </a:extLst>
            </p:cNvPr>
            <p:cNvSpPr txBox="1"/>
            <p:nvPr/>
          </p:nvSpPr>
          <p:spPr>
            <a:xfrm rot="19294338">
              <a:off x="2917563" y="17769020"/>
              <a:ext cx="465735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/>
                <a:t>C901</a:t>
              </a:r>
            </a:p>
          </p:txBody>
        </p:sp>
        <p:sp>
          <p:nvSpPr>
            <p:cNvPr id="88" name="ZoneTexte 29">
              <a:extLst>
                <a:ext uri="{FF2B5EF4-FFF2-40B4-BE49-F238E27FC236}">
                  <a16:creationId xmlns:a16="http://schemas.microsoft.com/office/drawing/2014/main" id="{2D7538F4-E9E9-E6E2-9047-01B380552C9B}"/>
                </a:ext>
              </a:extLst>
            </p:cNvPr>
            <p:cNvSpPr txBox="1"/>
            <p:nvPr/>
          </p:nvSpPr>
          <p:spPr>
            <a:xfrm rot="19097700">
              <a:off x="3710483" y="17777267"/>
              <a:ext cx="471382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 dirty="0"/>
                <a:t>G266</a:t>
              </a:r>
            </a:p>
          </p:txBody>
        </p:sp>
        <p:sp>
          <p:nvSpPr>
            <p:cNvPr id="89" name="ZoneTexte 30">
              <a:extLst>
                <a:ext uri="{FF2B5EF4-FFF2-40B4-BE49-F238E27FC236}">
                  <a16:creationId xmlns:a16="http://schemas.microsoft.com/office/drawing/2014/main" id="{80E46FEB-3515-96A0-FFF5-3DAF6B4F8D35}"/>
                </a:ext>
              </a:extLst>
            </p:cNvPr>
            <p:cNvSpPr txBox="1"/>
            <p:nvPr/>
          </p:nvSpPr>
          <p:spPr>
            <a:xfrm rot="18922973">
              <a:off x="4324561" y="17854197"/>
              <a:ext cx="675845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/>
                <a:t>PCU-012</a:t>
              </a:r>
            </a:p>
          </p:txBody>
        </p:sp>
        <p:sp>
          <p:nvSpPr>
            <p:cNvPr id="94" name="ZoneTexte 31">
              <a:extLst>
                <a:ext uri="{FF2B5EF4-FFF2-40B4-BE49-F238E27FC236}">
                  <a16:creationId xmlns:a16="http://schemas.microsoft.com/office/drawing/2014/main" id="{D943840C-3E9B-B639-1253-67CE3BB8AFEF}"/>
                </a:ext>
              </a:extLst>
            </p:cNvPr>
            <p:cNvSpPr txBox="1"/>
            <p:nvPr/>
          </p:nvSpPr>
          <p:spPr>
            <a:xfrm rot="18834489">
              <a:off x="5106445" y="17859598"/>
              <a:ext cx="679152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/>
                <a:t>PCU-018</a:t>
              </a:r>
            </a:p>
          </p:txBody>
        </p:sp>
      </p:grpSp>
      <p:grpSp>
        <p:nvGrpSpPr>
          <p:cNvPr id="95" name="Groupe 94">
            <a:extLst>
              <a:ext uri="{FF2B5EF4-FFF2-40B4-BE49-F238E27FC236}">
                <a16:creationId xmlns:a16="http://schemas.microsoft.com/office/drawing/2014/main" id="{BB8A2D16-5D3E-F4E9-6911-3EAF7121A2A3}"/>
              </a:ext>
            </a:extLst>
          </p:cNvPr>
          <p:cNvGrpSpPr/>
          <p:nvPr/>
        </p:nvGrpSpPr>
        <p:grpSpPr>
          <a:xfrm>
            <a:off x="16763211" y="14388778"/>
            <a:ext cx="3455048" cy="679152"/>
            <a:chOff x="2094847" y="17623897"/>
            <a:chExt cx="3455048" cy="679152"/>
          </a:xfrm>
        </p:grpSpPr>
        <p:sp>
          <p:nvSpPr>
            <p:cNvPr id="99" name="ZoneTexte 27">
              <a:extLst>
                <a:ext uri="{FF2B5EF4-FFF2-40B4-BE49-F238E27FC236}">
                  <a16:creationId xmlns:a16="http://schemas.microsoft.com/office/drawing/2014/main" id="{2F386590-E037-5EDA-3169-D3859D8A1583}"/>
                </a:ext>
              </a:extLst>
            </p:cNvPr>
            <p:cNvSpPr txBox="1"/>
            <p:nvPr/>
          </p:nvSpPr>
          <p:spPr>
            <a:xfrm rot="19376873">
              <a:off x="2094847" y="17784768"/>
              <a:ext cx="527615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/>
                <a:t>C1022</a:t>
              </a:r>
            </a:p>
          </p:txBody>
        </p:sp>
        <p:sp>
          <p:nvSpPr>
            <p:cNvPr id="100" name="ZoneTexte 28">
              <a:extLst>
                <a:ext uri="{FF2B5EF4-FFF2-40B4-BE49-F238E27FC236}">
                  <a16:creationId xmlns:a16="http://schemas.microsoft.com/office/drawing/2014/main" id="{55CF20AF-73A8-0D68-B9CF-7C0D757BB3E1}"/>
                </a:ext>
              </a:extLst>
            </p:cNvPr>
            <p:cNvSpPr txBox="1"/>
            <p:nvPr/>
          </p:nvSpPr>
          <p:spPr>
            <a:xfrm rot="19294338">
              <a:off x="2917563" y="17769020"/>
              <a:ext cx="465735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/>
                <a:t>C901</a:t>
              </a:r>
            </a:p>
          </p:txBody>
        </p:sp>
        <p:sp>
          <p:nvSpPr>
            <p:cNvPr id="105" name="ZoneTexte 29">
              <a:extLst>
                <a:ext uri="{FF2B5EF4-FFF2-40B4-BE49-F238E27FC236}">
                  <a16:creationId xmlns:a16="http://schemas.microsoft.com/office/drawing/2014/main" id="{755D6270-5562-D594-4650-A2A9B470470F}"/>
                </a:ext>
              </a:extLst>
            </p:cNvPr>
            <p:cNvSpPr txBox="1"/>
            <p:nvPr/>
          </p:nvSpPr>
          <p:spPr>
            <a:xfrm rot="19097700">
              <a:off x="3710483" y="17777267"/>
              <a:ext cx="471382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 dirty="0"/>
                <a:t>G266</a:t>
              </a:r>
            </a:p>
          </p:txBody>
        </p:sp>
        <p:sp>
          <p:nvSpPr>
            <p:cNvPr id="106" name="ZoneTexte 30">
              <a:extLst>
                <a:ext uri="{FF2B5EF4-FFF2-40B4-BE49-F238E27FC236}">
                  <a16:creationId xmlns:a16="http://schemas.microsoft.com/office/drawing/2014/main" id="{ADB0198F-A9D8-7DA4-8559-13125091B818}"/>
                </a:ext>
              </a:extLst>
            </p:cNvPr>
            <p:cNvSpPr txBox="1"/>
            <p:nvPr/>
          </p:nvSpPr>
          <p:spPr>
            <a:xfrm rot="18922973">
              <a:off x="4324561" y="17854197"/>
              <a:ext cx="675845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/>
                <a:t>PCU-012</a:t>
              </a:r>
            </a:p>
          </p:txBody>
        </p:sp>
        <p:sp>
          <p:nvSpPr>
            <p:cNvPr id="107" name="ZoneTexte 31">
              <a:extLst>
                <a:ext uri="{FF2B5EF4-FFF2-40B4-BE49-F238E27FC236}">
                  <a16:creationId xmlns:a16="http://schemas.microsoft.com/office/drawing/2014/main" id="{88C11801-311D-7DE6-C07D-F48F715464FB}"/>
                </a:ext>
              </a:extLst>
            </p:cNvPr>
            <p:cNvSpPr txBox="1"/>
            <p:nvPr/>
          </p:nvSpPr>
          <p:spPr>
            <a:xfrm rot="18834489">
              <a:off x="5106445" y="17859598"/>
              <a:ext cx="679152" cy="20774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fr-FR" sz="1350"/>
                <a:t>PCU-01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7784102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BFF3963F00EB54E9A3761152733AC6A" ma:contentTypeVersion="4" ma:contentTypeDescription="Create a new document." ma:contentTypeScope="" ma:versionID="e7ffe98eff975e76c50d3452d9430135">
  <xsd:schema xmlns:xsd="http://www.w3.org/2001/XMLSchema" xmlns:xs="http://www.w3.org/2001/XMLSchema" xmlns:p="http://schemas.microsoft.com/office/2006/metadata/properties" xmlns:ns2="b0fabec9-6a62-41a8-94aa-3905766af3d1" xmlns:ns3="e4da75e6-af4f-48ad-8689-e58586a6a97d" targetNamespace="http://schemas.microsoft.com/office/2006/metadata/properties" ma:root="true" ma:fieldsID="b175bc2b261cd1d35f2b535bc3efeb99" ns2:_="" ns3:_="">
    <xsd:import namespace="b0fabec9-6a62-41a8-94aa-3905766af3d1"/>
    <xsd:import namespace="e4da75e6-af4f-48ad-8689-e58586a6a97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0fabec9-6a62-41a8-94aa-3905766af3d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4da75e6-af4f-48ad-8689-e58586a6a97d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D5E1CC3-A58D-45FD-88B2-E618E11A63A6}">
  <ds:schemaRefs>
    <ds:schemaRef ds:uri="http://purl.org/dc/elements/1.1/"/>
    <ds:schemaRef ds:uri="http://schemas.openxmlformats.org/package/2006/metadata/core-properties"/>
    <ds:schemaRef ds:uri="http://purl.org/dc/terms/"/>
    <ds:schemaRef ds:uri="http://schemas.microsoft.com/office/2006/documentManagement/types"/>
    <ds:schemaRef ds:uri="http://purl.org/dc/dcmitype/"/>
    <ds:schemaRef ds:uri="http://schemas.microsoft.com/office/infopath/2007/PartnerControls"/>
    <ds:schemaRef ds:uri="http://schemas.microsoft.com/office/2006/metadata/properties"/>
    <ds:schemaRef ds:uri="e4da75e6-af4f-48ad-8689-e58586a6a97d"/>
    <ds:schemaRef ds:uri="b0fabec9-6a62-41a8-94aa-3905766af3d1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D48A517C-D241-44EF-B3A3-E3C68336E27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62FB2FD-B248-4779-A05C-16FF59270645}">
  <ds:schemaRefs>
    <ds:schemaRef ds:uri="b0fabec9-6a62-41a8-94aa-3905766af3d1"/>
    <ds:schemaRef ds:uri="e4da75e6-af4f-48ad-8689-e58586a6a97d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</TotalTime>
  <Words>86</Words>
  <Application>Microsoft Office PowerPoint</Application>
  <PresentationFormat>Personnalisé</PresentationFormat>
  <Paragraphs>4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Yolande Misseri</dc:creator>
  <cp:lastModifiedBy>Nadege Bidan</cp:lastModifiedBy>
  <cp:revision>3</cp:revision>
  <cp:lastPrinted>2022-10-19T14:14:40Z</cp:lastPrinted>
  <dcterms:created xsi:type="dcterms:W3CDTF">2022-10-17T11:09:06Z</dcterms:created>
  <dcterms:modified xsi:type="dcterms:W3CDTF">2023-02-16T13:45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BFF3963F00EB54E9A3761152733AC6A</vt:lpwstr>
  </property>
  <property fmtid="{D5CDD505-2E9C-101B-9397-08002B2CF9AE}" pid="3" name="MediaServiceImageTags">
    <vt:lpwstr/>
  </property>
</Properties>
</file>